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  <p:sldId id="258" r:id="rId5"/>
    <p:sldId id="261" r:id="rId6"/>
    <p:sldId id="262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5A7CD37-6563-4387-96D1-C3B1839948C1}" v="2" dt="2025-04-29T09:00:40.74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SCA PAOLA NOCERA" userId="abafb519-3acb-45b6-b440-eaa72f2ef793" providerId="ADAL" clId="{75A7CD37-6563-4387-96D1-C3B1839948C1}"/>
    <pc:docChg chg="undo custSel addSld delSld modSld">
      <pc:chgData name="FRANCESCA PAOLA NOCERA" userId="abafb519-3acb-45b6-b440-eaa72f2ef793" providerId="ADAL" clId="{75A7CD37-6563-4387-96D1-C3B1839948C1}" dt="2025-04-29T09:19:25.776" v="203" actId="1076"/>
      <pc:docMkLst>
        <pc:docMk/>
      </pc:docMkLst>
      <pc:sldChg chg="del">
        <pc:chgData name="FRANCESCA PAOLA NOCERA" userId="abafb519-3acb-45b6-b440-eaa72f2ef793" providerId="ADAL" clId="{75A7CD37-6563-4387-96D1-C3B1839948C1}" dt="2025-04-29T08:59:17.011" v="0" actId="2696"/>
        <pc:sldMkLst>
          <pc:docMk/>
          <pc:sldMk cId="2928736985" sldId="256"/>
        </pc:sldMkLst>
      </pc:sldChg>
      <pc:sldChg chg="addSp delSp modSp mod">
        <pc:chgData name="FRANCESCA PAOLA NOCERA" userId="abafb519-3acb-45b6-b440-eaa72f2ef793" providerId="ADAL" clId="{75A7CD37-6563-4387-96D1-C3B1839948C1}" dt="2025-04-29T09:17:02.690" v="176" actId="20577"/>
        <pc:sldMkLst>
          <pc:docMk/>
          <pc:sldMk cId="276604740" sldId="257"/>
        </pc:sldMkLst>
        <pc:spChg chg="mod">
          <ac:chgData name="FRANCESCA PAOLA NOCERA" userId="abafb519-3acb-45b6-b440-eaa72f2ef793" providerId="ADAL" clId="{75A7CD37-6563-4387-96D1-C3B1839948C1}" dt="2025-04-29T09:17:02.690" v="176" actId="20577"/>
          <ac:spMkLst>
            <pc:docMk/>
            <pc:sldMk cId="276604740" sldId="257"/>
            <ac:spMk id="10" creationId="{8D874BF5-681C-9926-A09D-16E50DE29FD0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14" creationId="{6C928E59-9EF9-785A-4B4E-4F87D7F6C14A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16" creationId="{D20D8312-940A-5559-5A41-A585541D2B4B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19" creationId="{7B8E7F5F-2A2B-97AE-7AAE-5D7BC0C2624B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0" creationId="{B52EC4E5-8BA8-770C-012E-A261F860FBA0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1" creationId="{0F903397-0A3D-1382-533E-B17BE695D832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2" creationId="{BEB657D6-1C92-8ED6-5C04-0DF9767E9208}"/>
          </ac:spMkLst>
        </pc:spChg>
        <pc:spChg chg="del">
          <ac:chgData name="FRANCESCA PAOLA NOCERA" userId="abafb519-3acb-45b6-b440-eaa72f2ef793" providerId="ADAL" clId="{75A7CD37-6563-4387-96D1-C3B1839948C1}" dt="2025-04-29T09:00:50.233" v="7" actId="478"/>
          <ac:spMkLst>
            <pc:docMk/>
            <pc:sldMk cId="276604740" sldId="257"/>
            <ac:spMk id="25" creationId="{02EFE25B-7DDA-E537-014A-DE90E92FEB17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6" creationId="{2E32C92B-B648-64A7-FFD3-B8270D3E8B24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7" creationId="{40D6F215-3612-5D96-587E-83FD6CAD0FF1}"/>
          </ac:spMkLst>
        </pc:spChg>
        <pc:spChg chg="mod">
          <ac:chgData name="FRANCESCA PAOLA NOCERA" userId="abafb519-3acb-45b6-b440-eaa72f2ef793" providerId="ADAL" clId="{75A7CD37-6563-4387-96D1-C3B1839948C1}" dt="2025-04-29T09:00:37.948" v="4" actId="165"/>
          <ac:spMkLst>
            <pc:docMk/>
            <pc:sldMk cId="276604740" sldId="257"/>
            <ac:spMk id="28" creationId="{1BE1C87F-A216-178F-5EDE-9DA7105342D3}"/>
          </ac:spMkLst>
        </pc:spChg>
        <pc:spChg chg="mod topLvl">
          <ac:chgData name="FRANCESCA PAOLA NOCERA" userId="abafb519-3acb-45b6-b440-eaa72f2ef793" providerId="ADAL" clId="{75A7CD37-6563-4387-96D1-C3B1839948C1}" dt="2025-04-29T09:00:40.749" v="5" actId="338"/>
          <ac:spMkLst>
            <pc:docMk/>
            <pc:sldMk cId="276604740" sldId="257"/>
            <ac:spMk id="31" creationId="{E7FAE862-8207-4B22-B046-688050F42E4D}"/>
          </ac:spMkLst>
        </pc:spChg>
        <pc:spChg chg="mod">
          <ac:chgData name="FRANCESCA PAOLA NOCERA" userId="abafb519-3acb-45b6-b440-eaa72f2ef793" providerId="ADAL" clId="{75A7CD37-6563-4387-96D1-C3B1839948C1}" dt="2025-04-29T09:01:59.584" v="24" actId="20577"/>
          <ac:spMkLst>
            <pc:docMk/>
            <pc:sldMk cId="276604740" sldId="257"/>
            <ac:spMk id="55" creationId="{2CFA35CF-E49B-F7A2-68DC-517457ABBE58}"/>
          </ac:spMkLst>
        </pc:spChg>
        <pc:grpChg chg="mod">
          <ac:chgData name="FRANCESCA PAOLA NOCERA" userId="abafb519-3acb-45b6-b440-eaa72f2ef793" providerId="ADAL" clId="{75A7CD37-6563-4387-96D1-C3B1839948C1}" dt="2025-04-29T09:12:07.054" v="85" actId="1076"/>
          <ac:grpSpMkLst>
            <pc:docMk/>
            <pc:sldMk cId="276604740" sldId="257"/>
            <ac:grpSpMk id="12" creationId="{171A3D78-D406-FFDA-F09D-644FB81762CA}"/>
          </ac:grpSpMkLst>
        </pc:grpChg>
        <pc:grpChg chg="add del mod">
          <ac:chgData name="FRANCESCA PAOLA NOCERA" userId="abafb519-3acb-45b6-b440-eaa72f2ef793" providerId="ADAL" clId="{75A7CD37-6563-4387-96D1-C3B1839948C1}" dt="2025-04-29T09:12:02.833" v="84" actId="478"/>
          <ac:grpSpMkLst>
            <pc:docMk/>
            <pc:sldMk cId="276604740" sldId="257"/>
            <ac:grpSpMk id="24" creationId="{972EFAD3-DC83-8378-CEDC-E83A912C08A6}"/>
          </ac:grpSpMkLst>
        </pc:grpChg>
        <pc:grpChg chg="mod">
          <ac:chgData name="FRANCESCA PAOLA NOCERA" userId="abafb519-3acb-45b6-b440-eaa72f2ef793" providerId="ADAL" clId="{75A7CD37-6563-4387-96D1-C3B1839948C1}" dt="2025-04-29T09:00:40.749" v="5" actId="338"/>
          <ac:grpSpMkLst>
            <pc:docMk/>
            <pc:sldMk cId="276604740" sldId="257"/>
            <ac:grpSpMk id="41" creationId="{00677272-B7E1-381E-3884-B4DE4E8CD677}"/>
          </ac:grpSpMkLst>
        </pc:grpChg>
        <pc:grpChg chg="mod">
          <ac:chgData name="FRANCESCA PAOLA NOCERA" userId="abafb519-3acb-45b6-b440-eaa72f2ef793" providerId="ADAL" clId="{75A7CD37-6563-4387-96D1-C3B1839948C1}" dt="2025-04-29T08:59:50.566" v="3" actId="1076"/>
          <ac:grpSpMkLst>
            <pc:docMk/>
            <pc:sldMk cId="276604740" sldId="257"/>
            <ac:grpSpMk id="42" creationId="{E1F511A9-ED8F-A81A-079A-9B1685B56735}"/>
          </ac:grpSpMkLst>
        </pc:grpChg>
        <pc:grpChg chg="del">
          <ac:chgData name="FRANCESCA PAOLA NOCERA" userId="abafb519-3acb-45b6-b440-eaa72f2ef793" providerId="ADAL" clId="{75A7CD37-6563-4387-96D1-C3B1839948C1}" dt="2025-04-29T08:59:44.401" v="1" actId="478"/>
          <ac:grpSpMkLst>
            <pc:docMk/>
            <pc:sldMk cId="276604740" sldId="257"/>
            <ac:grpSpMk id="46" creationId="{C4F7488A-2DAB-66B4-A768-74413B26E0D6}"/>
          </ac:grpSpMkLst>
        </pc:grpChg>
        <pc:grpChg chg="del mod">
          <ac:chgData name="FRANCESCA PAOLA NOCERA" userId="abafb519-3acb-45b6-b440-eaa72f2ef793" providerId="ADAL" clId="{75A7CD37-6563-4387-96D1-C3B1839948C1}" dt="2025-04-29T09:12:01.021" v="83" actId="478"/>
          <ac:grpSpMkLst>
            <pc:docMk/>
            <pc:sldMk cId="276604740" sldId="257"/>
            <ac:grpSpMk id="56" creationId="{4F14A5DA-169D-A2AA-53FE-A1D3B9235B01}"/>
          </ac:grpSpMkLst>
        </pc:grpChg>
        <pc:picChg chg="mod">
          <ac:chgData name="FRANCESCA PAOLA NOCERA" userId="abafb519-3acb-45b6-b440-eaa72f2ef793" providerId="ADAL" clId="{75A7CD37-6563-4387-96D1-C3B1839948C1}" dt="2025-04-29T09:03:06.580" v="38" actId="1076"/>
          <ac:picMkLst>
            <pc:docMk/>
            <pc:sldMk cId="276604740" sldId="257"/>
            <ac:picMk id="2" creationId="{251519C4-9082-3F4E-BFB0-FC56ADC603FD}"/>
          </ac:picMkLst>
        </pc:picChg>
        <pc:picChg chg="mod">
          <ac:chgData name="FRANCESCA PAOLA NOCERA" userId="abafb519-3acb-45b6-b440-eaa72f2ef793" providerId="ADAL" clId="{75A7CD37-6563-4387-96D1-C3B1839948C1}" dt="2025-04-29T09:00:40.749" v="5" actId="338"/>
          <ac:picMkLst>
            <pc:docMk/>
            <pc:sldMk cId="276604740" sldId="257"/>
            <ac:picMk id="13" creationId="{78403EF5-C9C1-CC86-C0FC-617255F6BD6D}"/>
          </ac:picMkLst>
        </pc:picChg>
      </pc:sldChg>
      <pc:sldChg chg="addSp delSp modSp mod">
        <pc:chgData name="FRANCESCA PAOLA NOCERA" userId="abafb519-3acb-45b6-b440-eaa72f2ef793" providerId="ADAL" clId="{75A7CD37-6563-4387-96D1-C3B1839948C1}" dt="2025-04-29T09:18:31.883" v="198" actId="1076"/>
        <pc:sldMkLst>
          <pc:docMk/>
          <pc:sldMk cId="602764107" sldId="258"/>
        </pc:sldMkLst>
        <pc:spChg chg="mod">
          <ac:chgData name="FRANCESCA PAOLA NOCERA" userId="abafb519-3acb-45b6-b440-eaa72f2ef793" providerId="ADAL" clId="{75A7CD37-6563-4387-96D1-C3B1839948C1}" dt="2025-04-29T09:18:31.883" v="198" actId="1076"/>
          <ac:spMkLst>
            <pc:docMk/>
            <pc:sldMk cId="602764107" sldId="258"/>
            <ac:spMk id="58" creationId="{C5E65008-BDE6-28F0-A288-9B7A4A7659F9}"/>
          </ac:spMkLst>
        </pc:spChg>
        <pc:grpChg chg="del mod">
          <ac:chgData name="FRANCESCA PAOLA NOCERA" userId="abafb519-3acb-45b6-b440-eaa72f2ef793" providerId="ADAL" clId="{75A7CD37-6563-4387-96D1-C3B1839948C1}" dt="2025-04-29T09:13:40.834" v="122" actId="478"/>
          <ac:grpSpMkLst>
            <pc:docMk/>
            <pc:sldMk cId="602764107" sldId="258"/>
            <ac:grpSpMk id="24" creationId="{8558CB46-5441-CF1A-CABB-4D971A247AA9}"/>
          </ac:grpSpMkLst>
        </pc:grpChg>
        <pc:grpChg chg="del mod">
          <ac:chgData name="FRANCESCA PAOLA NOCERA" userId="abafb519-3acb-45b6-b440-eaa72f2ef793" providerId="ADAL" clId="{75A7CD37-6563-4387-96D1-C3B1839948C1}" dt="2025-04-29T09:13:47.663" v="125" actId="478"/>
          <ac:grpSpMkLst>
            <pc:docMk/>
            <pc:sldMk cId="602764107" sldId="258"/>
            <ac:grpSpMk id="26" creationId="{FD2B19ED-B18C-93CC-1837-6DFC61243B63}"/>
          </ac:grpSpMkLst>
        </pc:grpChg>
        <pc:grpChg chg="mod">
          <ac:chgData name="FRANCESCA PAOLA NOCERA" userId="abafb519-3acb-45b6-b440-eaa72f2ef793" providerId="ADAL" clId="{75A7CD37-6563-4387-96D1-C3B1839948C1}" dt="2025-04-29T09:18:18.874" v="195" actId="1076"/>
          <ac:grpSpMkLst>
            <pc:docMk/>
            <pc:sldMk cId="602764107" sldId="258"/>
            <ac:grpSpMk id="59" creationId="{B1EDB50D-43F0-DAA5-DDC7-11854929337B}"/>
          </ac:grpSpMkLst>
        </pc:grpChg>
        <pc:picChg chg="add del mod">
          <ac:chgData name="FRANCESCA PAOLA NOCERA" userId="abafb519-3acb-45b6-b440-eaa72f2ef793" providerId="ADAL" clId="{75A7CD37-6563-4387-96D1-C3B1839948C1}" dt="2025-04-29T09:13:45.362" v="124" actId="478"/>
          <ac:picMkLst>
            <pc:docMk/>
            <pc:sldMk cId="602764107" sldId="258"/>
            <ac:picMk id="25" creationId="{B99F3DB3-FEF2-3DFB-A7D5-30C9B9F85AB4}"/>
          </ac:picMkLst>
        </pc:picChg>
      </pc:sldChg>
      <pc:sldChg chg="delSp modSp add mod">
        <pc:chgData name="FRANCESCA PAOLA NOCERA" userId="abafb519-3acb-45b6-b440-eaa72f2ef793" providerId="ADAL" clId="{75A7CD37-6563-4387-96D1-C3B1839948C1}" dt="2025-04-29T09:18:13.913" v="194" actId="1076"/>
        <pc:sldMkLst>
          <pc:docMk/>
          <pc:sldMk cId="29389134" sldId="259"/>
        </pc:sldMkLst>
        <pc:spChg chg="mod">
          <ac:chgData name="FRANCESCA PAOLA NOCERA" userId="abafb519-3acb-45b6-b440-eaa72f2ef793" providerId="ADAL" clId="{75A7CD37-6563-4387-96D1-C3B1839948C1}" dt="2025-04-29T09:17:36.718" v="188" actId="14100"/>
          <ac:spMkLst>
            <pc:docMk/>
            <pc:sldMk cId="29389134" sldId="259"/>
            <ac:spMk id="55" creationId="{38F7D2CC-39FC-9252-9AC7-A2052353A348}"/>
          </ac:spMkLst>
        </pc:spChg>
        <pc:grpChg chg="del">
          <ac:chgData name="FRANCESCA PAOLA NOCERA" userId="abafb519-3acb-45b6-b440-eaa72f2ef793" providerId="ADAL" clId="{75A7CD37-6563-4387-96D1-C3B1839948C1}" dt="2025-04-29T09:12:45.983" v="86" actId="478"/>
          <ac:grpSpMkLst>
            <pc:docMk/>
            <pc:sldMk cId="29389134" sldId="259"/>
            <ac:grpSpMk id="12" creationId="{91DAC1C4-2EDF-7965-2442-0B6281B6FF48}"/>
          </ac:grpSpMkLst>
        </pc:grpChg>
        <pc:grpChg chg="del">
          <ac:chgData name="FRANCESCA PAOLA NOCERA" userId="abafb519-3acb-45b6-b440-eaa72f2ef793" providerId="ADAL" clId="{75A7CD37-6563-4387-96D1-C3B1839948C1}" dt="2025-04-29T09:12:48.827" v="87" actId="478"/>
          <ac:grpSpMkLst>
            <pc:docMk/>
            <pc:sldMk cId="29389134" sldId="259"/>
            <ac:grpSpMk id="24" creationId="{A583320B-A3E6-18E7-01F8-675FF1CD6921}"/>
          </ac:grpSpMkLst>
        </pc:grpChg>
        <pc:grpChg chg="mod">
          <ac:chgData name="FRANCESCA PAOLA NOCERA" userId="abafb519-3acb-45b6-b440-eaa72f2ef793" providerId="ADAL" clId="{75A7CD37-6563-4387-96D1-C3B1839948C1}" dt="2025-04-29T09:18:13.913" v="194" actId="1076"/>
          <ac:grpSpMkLst>
            <pc:docMk/>
            <pc:sldMk cId="29389134" sldId="259"/>
            <ac:grpSpMk id="56" creationId="{A39269F9-04BF-C21A-585E-C8814E7D03F6}"/>
          </ac:grpSpMkLst>
        </pc:grpChg>
      </pc:sldChg>
      <pc:sldChg chg="delSp modSp add mod">
        <pc:chgData name="FRANCESCA PAOLA NOCERA" userId="abafb519-3acb-45b6-b440-eaa72f2ef793" providerId="ADAL" clId="{75A7CD37-6563-4387-96D1-C3B1839948C1}" dt="2025-04-29T09:18:08.244" v="193" actId="1076"/>
        <pc:sldMkLst>
          <pc:docMk/>
          <pc:sldMk cId="3558656932" sldId="260"/>
        </pc:sldMkLst>
        <pc:spChg chg="mod">
          <ac:chgData name="FRANCESCA PAOLA NOCERA" userId="abafb519-3acb-45b6-b440-eaa72f2ef793" providerId="ADAL" clId="{75A7CD37-6563-4387-96D1-C3B1839948C1}" dt="2025-04-29T09:18:01.734" v="192" actId="1076"/>
          <ac:spMkLst>
            <pc:docMk/>
            <pc:sldMk cId="3558656932" sldId="260"/>
            <ac:spMk id="31" creationId="{B92E308A-CC14-C4D5-9633-EA069AB1ABFC}"/>
          </ac:spMkLst>
        </pc:spChg>
        <pc:grpChg chg="del">
          <ac:chgData name="FRANCESCA PAOLA NOCERA" userId="abafb519-3acb-45b6-b440-eaa72f2ef793" providerId="ADAL" clId="{75A7CD37-6563-4387-96D1-C3B1839948C1}" dt="2025-04-29T09:13:09.418" v="105" actId="478"/>
          <ac:grpSpMkLst>
            <pc:docMk/>
            <pc:sldMk cId="3558656932" sldId="260"/>
            <ac:grpSpMk id="12" creationId="{2FD705A4-5D5F-B3D3-E2EF-91210F626A13}"/>
          </ac:grpSpMkLst>
        </pc:grpChg>
        <pc:grpChg chg="mod">
          <ac:chgData name="FRANCESCA PAOLA NOCERA" userId="abafb519-3acb-45b6-b440-eaa72f2ef793" providerId="ADAL" clId="{75A7CD37-6563-4387-96D1-C3B1839948C1}" dt="2025-04-29T09:18:08.244" v="193" actId="1076"/>
          <ac:grpSpMkLst>
            <pc:docMk/>
            <pc:sldMk cId="3558656932" sldId="260"/>
            <ac:grpSpMk id="24" creationId="{4996B0A4-1B96-ED3C-ADAB-1AE098CDFFBD}"/>
          </ac:grpSpMkLst>
        </pc:grpChg>
        <pc:grpChg chg="del">
          <ac:chgData name="FRANCESCA PAOLA NOCERA" userId="abafb519-3acb-45b6-b440-eaa72f2ef793" providerId="ADAL" clId="{75A7CD37-6563-4387-96D1-C3B1839948C1}" dt="2025-04-29T09:13:07.840" v="104" actId="478"/>
          <ac:grpSpMkLst>
            <pc:docMk/>
            <pc:sldMk cId="3558656932" sldId="260"/>
            <ac:grpSpMk id="56" creationId="{F771BD16-37CD-2E1D-F923-789B3EAEF2F1}"/>
          </ac:grpSpMkLst>
        </pc:grpChg>
      </pc:sldChg>
      <pc:sldChg chg="delSp modSp add mod">
        <pc:chgData name="FRANCESCA PAOLA NOCERA" userId="abafb519-3acb-45b6-b440-eaa72f2ef793" providerId="ADAL" clId="{75A7CD37-6563-4387-96D1-C3B1839948C1}" dt="2025-04-29T09:18:47.952" v="200" actId="1076"/>
        <pc:sldMkLst>
          <pc:docMk/>
          <pc:sldMk cId="1552205219" sldId="261"/>
        </pc:sldMkLst>
        <pc:spChg chg="mod">
          <ac:chgData name="FRANCESCA PAOLA NOCERA" userId="abafb519-3acb-45b6-b440-eaa72f2ef793" providerId="ADAL" clId="{75A7CD37-6563-4387-96D1-C3B1839948C1}" dt="2025-04-29T09:18:47.952" v="200" actId="1076"/>
          <ac:spMkLst>
            <pc:docMk/>
            <pc:sldMk cId="1552205219" sldId="261"/>
            <ac:spMk id="34" creationId="{19F4990B-88CF-90AC-3630-5F174B3CDBF0}"/>
          </ac:spMkLst>
        </pc:spChg>
        <pc:grpChg chg="del">
          <ac:chgData name="FRANCESCA PAOLA NOCERA" userId="abafb519-3acb-45b6-b440-eaa72f2ef793" providerId="ADAL" clId="{75A7CD37-6563-4387-96D1-C3B1839948C1}" dt="2025-04-29T09:14:04.015" v="140" actId="478"/>
          <ac:grpSpMkLst>
            <pc:docMk/>
            <pc:sldMk cId="1552205219" sldId="261"/>
            <ac:grpSpMk id="24" creationId="{E6906015-942B-3BBD-1242-DA1B1D4D1F9D}"/>
          </ac:grpSpMkLst>
        </pc:grpChg>
        <pc:grpChg chg="mod">
          <ac:chgData name="FRANCESCA PAOLA NOCERA" userId="abafb519-3acb-45b6-b440-eaa72f2ef793" providerId="ADAL" clId="{75A7CD37-6563-4387-96D1-C3B1839948C1}" dt="2025-04-29T09:14:41.213" v="168" actId="1076"/>
          <ac:grpSpMkLst>
            <pc:docMk/>
            <pc:sldMk cId="1552205219" sldId="261"/>
            <ac:grpSpMk id="26" creationId="{0B16CEA5-64BB-E2BA-026B-FCFD81C8863E}"/>
          </ac:grpSpMkLst>
        </pc:grpChg>
        <pc:grpChg chg="del">
          <ac:chgData name="FRANCESCA PAOLA NOCERA" userId="abafb519-3acb-45b6-b440-eaa72f2ef793" providerId="ADAL" clId="{75A7CD37-6563-4387-96D1-C3B1839948C1}" dt="2025-04-29T09:14:05.252" v="141" actId="478"/>
          <ac:grpSpMkLst>
            <pc:docMk/>
            <pc:sldMk cId="1552205219" sldId="261"/>
            <ac:grpSpMk id="59" creationId="{6CD7E54D-9436-1325-9129-C59BCFEA6E9A}"/>
          </ac:grpSpMkLst>
        </pc:grpChg>
      </pc:sldChg>
      <pc:sldChg chg="delSp modSp add mod">
        <pc:chgData name="FRANCESCA PAOLA NOCERA" userId="abafb519-3acb-45b6-b440-eaa72f2ef793" providerId="ADAL" clId="{75A7CD37-6563-4387-96D1-C3B1839948C1}" dt="2025-04-29T09:19:25.776" v="203" actId="1076"/>
        <pc:sldMkLst>
          <pc:docMk/>
          <pc:sldMk cId="2344946619" sldId="262"/>
        </pc:sldMkLst>
        <pc:spChg chg="mod">
          <ac:chgData name="FRANCESCA PAOLA NOCERA" userId="abafb519-3acb-45b6-b440-eaa72f2ef793" providerId="ADAL" clId="{75A7CD37-6563-4387-96D1-C3B1839948C1}" dt="2025-04-29T09:19:19.272" v="202" actId="1076"/>
          <ac:spMkLst>
            <pc:docMk/>
            <pc:sldMk cId="2344946619" sldId="262"/>
            <ac:spMk id="2" creationId="{F848F74C-3574-A729-7246-F485184DF991}"/>
          </ac:spMkLst>
        </pc:spChg>
        <pc:grpChg chg="mod">
          <ac:chgData name="FRANCESCA PAOLA NOCERA" userId="abafb519-3acb-45b6-b440-eaa72f2ef793" providerId="ADAL" clId="{75A7CD37-6563-4387-96D1-C3B1839948C1}" dt="2025-04-29T09:19:25.776" v="203" actId="1076"/>
          <ac:grpSpMkLst>
            <pc:docMk/>
            <pc:sldMk cId="2344946619" sldId="262"/>
            <ac:grpSpMk id="24" creationId="{D609F452-BBF4-E1D6-8C60-615D8AE6F1E3}"/>
          </ac:grpSpMkLst>
        </pc:grpChg>
        <pc:grpChg chg="del">
          <ac:chgData name="FRANCESCA PAOLA NOCERA" userId="abafb519-3acb-45b6-b440-eaa72f2ef793" providerId="ADAL" clId="{75A7CD37-6563-4387-96D1-C3B1839948C1}" dt="2025-04-29T09:14:27.060" v="155" actId="478"/>
          <ac:grpSpMkLst>
            <pc:docMk/>
            <pc:sldMk cId="2344946619" sldId="262"/>
            <ac:grpSpMk id="26" creationId="{91B32AE5-5F82-BBEC-091E-B89D8E9611D9}"/>
          </ac:grpSpMkLst>
        </pc:grpChg>
        <pc:grpChg chg="del">
          <ac:chgData name="FRANCESCA PAOLA NOCERA" userId="abafb519-3acb-45b6-b440-eaa72f2ef793" providerId="ADAL" clId="{75A7CD37-6563-4387-96D1-C3B1839948C1}" dt="2025-04-29T09:14:25.799" v="154" actId="478"/>
          <ac:grpSpMkLst>
            <pc:docMk/>
            <pc:sldMk cId="2344946619" sldId="262"/>
            <ac:grpSpMk id="59" creationId="{6649F942-5B1A-B059-E4F5-D574EEC4C4D3}"/>
          </ac:grpSpMkLst>
        </pc:grpChg>
      </pc:sldChg>
    </pc:docChg>
  </pc:docChgLst>
  <pc:docChgLst>
    <pc:chgData name="FRANCESCA PAOLA NOCERA" userId="abafb519-3acb-45b6-b440-eaa72f2ef793" providerId="ADAL" clId="{45390E09-701E-4DD7-B090-1B2C03E6B4DB}"/>
    <pc:docChg chg="undo custSel addSld modSld">
      <pc:chgData name="FRANCESCA PAOLA NOCERA" userId="abafb519-3acb-45b6-b440-eaa72f2ef793" providerId="ADAL" clId="{45390E09-701E-4DD7-B090-1B2C03E6B4DB}" dt="2025-04-15T22:15:14.240" v="608" actId="20577"/>
      <pc:docMkLst>
        <pc:docMk/>
      </pc:docMkLst>
      <pc:sldChg chg="addSp delSp modSp mod">
        <pc:chgData name="FRANCESCA PAOLA NOCERA" userId="abafb519-3acb-45b6-b440-eaa72f2ef793" providerId="ADAL" clId="{45390E09-701E-4DD7-B090-1B2C03E6B4DB}" dt="2025-04-15T22:02:28.125" v="603" actId="14100"/>
        <pc:sldMkLst>
          <pc:docMk/>
          <pc:sldMk cId="276604740" sldId="257"/>
        </pc:sldMkLst>
      </pc:sldChg>
      <pc:sldChg chg="addSp delSp modSp new mod">
        <pc:chgData name="FRANCESCA PAOLA NOCERA" userId="abafb519-3acb-45b6-b440-eaa72f2ef793" providerId="ADAL" clId="{45390E09-701E-4DD7-B090-1B2C03E6B4DB}" dt="2025-04-15T22:15:14.240" v="608" actId="20577"/>
        <pc:sldMkLst>
          <pc:docMk/>
          <pc:sldMk cId="602764107" sldId="258"/>
        </pc:sldMkLst>
        <pc:spChg chg="add mod">
          <ac:chgData name="FRANCESCA PAOLA NOCERA" userId="abafb519-3acb-45b6-b440-eaa72f2ef793" providerId="ADAL" clId="{45390E09-701E-4DD7-B090-1B2C03E6B4DB}" dt="2025-04-15T21:44:59.491" v="562" actId="338"/>
          <ac:spMkLst>
            <pc:docMk/>
            <pc:sldMk cId="602764107" sldId="258"/>
            <ac:spMk id="2" creationId="{E2E3AD4C-CAEC-FDD5-DE98-C69CABF61F0E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3" creationId="{A3A3E2F1-CA0E-6D8F-2626-426BFA7CF249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4" creationId="{0A8DF973-B74E-A7B7-A1BE-5AB7D408C45C}"/>
          </ac:spMkLst>
        </pc:spChg>
        <pc:spChg chg="add mod">
          <ac:chgData name="FRANCESCA PAOLA NOCERA" userId="abafb519-3acb-45b6-b440-eaa72f2ef793" providerId="ADAL" clId="{45390E09-701E-4DD7-B090-1B2C03E6B4DB}" dt="2025-04-15T20:02:28.089" v="127" actId="20577"/>
          <ac:spMkLst>
            <pc:docMk/>
            <pc:sldMk cId="602764107" sldId="258"/>
            <ac:spMk id="5" creationId="{D1236508-4F92-8E8D-DA2D-FA7F76D04355}"/>
          </ac:spMkLst>
        </pc:spChg>
        <pc:spChg chg="add mod">
          <ac:chgData name="FRANCESCA PAOLA NOCERA" userId="abafb519-3acb-45b6-b440-eaa72f2ef793" providerId="ADAL" clId="{45390E09-701E-4DD7-B090-1B2C03E6B4DB}" dt="2025-04-15T20:21:54.627" v="300" actId="164"/>
          <ac:spMkLst>
            <pc:docMk/>
            <pc:sldMk cId="602764107" sldId="258"/>
            <ac:spMk id="6" creationId="{0EA0A734-EEF6-F41A-EDCC-DDCF6AFB9412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7" creationId="{29D08182-8C2C-4149-B266-9BD143023697}"/>
          </ac:spMkLst>
        </pc:spChg>
        <pc:spChg chg="add mod">
          <ac:chgData name="FRANCESCA PAOLA NOCERA" userId="abafb519-3acb-45b6-b440-eaa72f2ef793" providerId="ADAL" clId="{45390E09-701E-4DD7-B090-1B2C03E6B4DB}" dt="2025-04-15T20:16:22.798" v="278" actId="1036"/>
          <ac:spMkLst>
            <pc:docMk/>
            <pc:sldMk cId="602764107" sldId="258"/>
            <ac:spMk id="8" creationId="{B11A3CB5-E30A-F0CC-C9FA-B330739FE64F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9" creationId="{731A0D07-BEFB-F6A6-776B-62549F9CFA80}"/>
          </ac:spMkLst>
        </pc:spChg>
        <pc:spChg chg="add mod">
          <ac:chgData name="FRANCESCA PAOLA NOCERA" userId="abafb519-3acb-45b6-b440-eaa72f2ef793" providerId="ADAL" clId="{45390E09-701E-4DD7-B090-1B2C03E6B4DB}" dt="2025-04-15T20:21:54.627" v="300" actId="164"/>
          <ac:spMkLst>
            <pc:docMk/>
            <pc:sldMk cId="602764107" sldId="258"/>
            <ac:spMk id="10" creationId="{804C874F-9C3B-4FD1-9090-4203A33774EA}"/>
          </ac:spMkLst>
        </pc:spChg>
        <pc:spChg chg="add mod">
          <ac:chgData name="FRANCESCA PAOLA NOCERA" userId="abafb519-3acb-45b6-b440-eaa72f2ef793" providerId="ADAL" clId="{45390E09-701E-4DD7-B090-1B2C03E6B4DB}" dt="2025-04-15T20:21:54.627" v="300" actId="164"/>
          <ac:spMkLst>
            <pc:docMk/>
            <pc:sldMk cId="602764107" sldId="258"/>
            <ac:spMk id="11" creationId="{686C0C64-0875-FC83-8BAF-F07017BE8B90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12" creationId="{B340A182-5502-A5F6-AA10-C8839C886CFC}"/>
          </ac:spMkLst>
        </pc:spChg>
        <pc:spChg chg="add mod">
          <ac:chgData name="FRANCESCA PAOLA NOCERA" userId="abafb519-3acb-45b6-b440-eaa72f2ef793" providerId="ADAL" clId="{45390E09-701E-4DD7-B090-1B2C03E6B4DB}" dt="2025-04-15T20:12:23.318" v="249" actId="1037"/>
          <ac:spMkLst>
            <pc:docMk/>
            <pc:sldMk cId="602764107" sldId="258"/>
            <ac:spMk id="13" creationId="{6C3872C4-534D-65F5-7CE9-F72922F92A9C}"/>
          </ac:spMkLst>
        </pc:spChg>
        <pc:spChg chg="add mod">
          <ac:chgData name="FRANCESCA PAOLA NOCERA" userId="abafb519-3acb-45b6-b440-eaa72f2ef793" providerId="ADAL" clId="{45390E09-701E-4DD7-B090-1B2C03E6B4DB}" dt="2025-04-15T20:21:54.627" v="300" actId="164"/>
          <ac:spMkLst>
            <pc:docMk/>
            <pc:sldMk cId="602764107" sldId="258"/>
            <ac:spMk id="14" creationId="{C9C24EA6-4C77-7C12-9999-6BFD4517A12D}"/>
          </ac:spMkLst>
        </pc:spChg>
        <pc:spChg chg="add mod">
          <ac:chgData name="FRANCESCA PAOLA NOCERA" userId="abafb519-3acb-45b6-b440-eaa72f2ef793" providerId="ADAL" clId="{45390E09-701E-4DD7-B090-1B2C03E6B4DB}" dt="2025-04-15T20:18:30.019" v="299" actId="1076"/>
          <ac:spMkLst>
            <pc:docMk/>
            <pc:sldMk cId="602764107" sldId="258"/>
            <ac:spMk id="15" creationId="{60334041-DCAA-EEBE-B77C-D6430E163C32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16" creationId="{071CFB7C-DEF6-6541-08F2-1D60A9A605BA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17" creationId="{0D07A36D-7C6E-2326-B99B-7711393125B5}"/>
          </ac:spMkLst>
        </pc:spChg>
        <pc:spChg chg="add mod">
          <ac:chgData name="FRANCESCA PAOLA NOCERA" userId="abafb519-3acb-45b6-b440-eaa72f2ef793" providerId="ADAL" clId="{45390E09-701E-4DD7-B090-1B2C03E6B4DB}" dt="2025-04-15T20:21:54.627" v="300" actId="164"/>
          <ac:spMkLst>
            <pc:docMk/>
            <pc:sldMk cId="602764107" sldId="258"/>
            <ac:spMk id="18" creationId="{3150D6B3-C1E6-BFC0-F20E-AC0BBDC330CC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19" creationId="{B12B3279-3164-1CFF-FE14-399438FCE241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20" creationId="{2FD166D2-7768-FC62-E6DA-427E28366256}"/>
          </ac:spMkLst>
        </pc:spChg>
        <pc:spChg chg="add mod">
          <ac:chgData name="FRANCESCA PAOLA NOCERA" userId="abafb519-3acb-45b6-b440-eaa72f2ef793" providerId="ADAL" clId="{45390E09-701E-4DD7-B090-1B2C03E6B4DB}" dt="2025-04-15T21:44:55.907" v="561" actId="165"/>
          <ac:spMkLst>
            <pc:docMk/>
            <pc:sldMk cId="602764107" sldId="258"/>
            <ac:spMk id="21" creationId="{E19CEE82-14B3-C32C-8923-BA562CA8F5F6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27" creationId="{31793205-A521-8099-65DC-8A91BE32A240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28" creationId="{C81CA432-5868-EC05-B749-3196121909A5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29" creationId="{20B6349C-D542-281F-5E0B-CBB821C0DB42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31" creationId="{B50BE593-2B20-2B7A-61D7-BA6BDF3DE3A1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32" creationId="{B313895A-F794-0449-8AD2-0805273FA5A0}"/>
          </ac:spMkLst>
        </pc:spChg>
        <pc:spChg chg="add mod topLvl">
          <ac:chgData name="FRANCESCA PAOLA NOCERA" userId="abafb519-3acb-45b6-b440-eaa72f2ef793" providerId="ADAL" clId="{45390E09-701E-4DD7-B090-1B2C03E6B4DB}" dt="2025-04-15T21:47:33.441" v="564" actId="338"/>
          <ac:spMkLst>
            <pc:docMk/>
            <pc:sldMk cId="602764107" sldId="258"/>
            <ac:spMk id="33" creationId="{53B30106-D882-17F1-F03B-B05D5FF500E3}"/>
          </ac:spMkLst>
        </pc:spChg>
        <pc:spChg chg="add mod topLvl">
          <ac:chgData name="FRANCESCA PAOLA NOCERA" userId="abafb519-3acb-45b6-b440-eaa72f2ef793" providerId="ADAL" clId="{45390E09-701E-4DD7-B090-1B2C03E6B4DB}" dt="2025-04-15T22:15:14.240" v="608" actId="20577"/>
          <ac:spMkLst>
            <pc:docMk/>
            <pc:sldMk cId="602764107" sldId="258"/>
            <ac:spMk id="34" creationId="{A9044E22-94A3-392A-8D14-A710E679B19D}"/>
          </ac:spMkLst>
        </pc:spChg>
        <pc:spChg chg="add mod">
          <ac:chgData name="FRANCESCA PAOLA NOCERA" userId="abafb519-3acb-45b6-b440-eaa72f2ef793" providerId="ADAL" clId="{45390E09-701E-4DD7-B090-1B2C03E6B4DB}" dt="2025-04-15T21:06:52.285" v="428" actId="1076"/>
          <ac:spMkLst>
            <pc:docMk/>
            <pc:sldMk cId="602764107" sldId="258"/>
            <ac:spMk id="38" creationId="{42A947BC-D2FD-99FA-94FD-E3A5A0EE005E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39" creationId="{18F6406B-A305-00B3-2601-4D8408D36473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40" creationId="{3E116D43-FB23-D72B-FA76-A0F740CC6FBE}"/>
          </ac:spMkLst>
        </pc:spChg>
        <pc:spChg chg="add mod">
          <ac:chgData name="FRANCESCA PAOLA NOCERA" userId="abafb519-3acb-45b6-b440-eaa72f2ef793" providerId="ADAL" clId="{45390E09-701E-4DD7-B090-1B2C03E6B4DB}" dt="2025-04-15T21:11:18.435" v="473" actId="20577"/>
          <ac:spMkLst>
            <pc:docMk/>
            <pc:sldMk cId="602764107" sldId="258"/>
            <ac:spMk id="41" creationId="{AA442CA6-75A0-D358-0B80-E1DA7C893CAC}"/>
          </ac:spMkLst>
        </pc:spChg>
        <pc:spChg chg="add mod">
          <ac:chgData name="FRANCESCA PAOLA NOCERA" userId="abafb519-3acb-45b6-b440-eaa72f2ef793" providerId="ADAL" clId="{45390E09-701E-4DD7-B090-1B2C03E6B4DB}" dt="2025-04-15T21:11:20.731" v="475" actId="20577"/>
          <ac:spMkLst>
            <pc:docMk/>
            <pc:sldMk cId="602764107" sldId="258"/>
            <ac:spMk id="42" creationId="{7D7A61AE-7540-AEE3-4016-06112E70ED32}"/>
          </ac:spMkLst>
        </pc:spChg>
        <pc:spChg chg="add mod">
          <ac:chgData name="FRANCESCA PAOLA NOCERA" userId="abafb519-3acb-45b6-b440-eaa72f2ef793" providerId="ADAL" clId="{45390E09-701E-4DD7-B090-1B2C03E6B4DB}" dt="2025-04-15T21:11:23.062" v="477" actId="20577"/>
          <ac:spMkLst>
            <pc:docMk/>
            <pc:sldMk cId="602764107" sldId="258"/>
            <ac:spMk id="43" creationId="{7F084E0C-AE58-6260-37FC-C1FDCB3C058A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45" creationId="{BFAAF74B-06AF-46EB-4B2F-6B7A73E18A34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46" creationId="{1CE4655E-C248-574E-AB01-99903F56E284}"/>
          </ac:spMkLst>
        </pc:spChg>
        <pc:spChg chg="add mod">
          <ac:chgData name="FRANCESCA PAOLA NOCERA" userId="abafb519-3acb-45b6-b440-eaa72f2ef793" providerId="ADAL" clId="{45390E09-701E-4DD7-B090-1B2C03E6B4DB}" dt="2025-04-15T21:12:02.409" v="490" actId="20577"/>
          <ac:spMkLst>
            <pc:docMk/>
            <pc:sldMk cId="602764107" sldId="258"/>
            <ac:spMk id="47" creationId="{37FC8BBB-A80E-0A74-94CC-86EDA4EA16F2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48" creationId="{82A76890-05EC-1932-329B-31DEC10746F0}"/>
          </ac:spMkLst>
        </pc:spChg>
        <pc:spChg chg="add mod">
          <ac:chgData name="FRANCESCA PAOLA NOCERA" userId="abafb519-3acb-45b6-b440-eaa72f2ef793" providerId="ADAL" clId="{45390E09-701E-4DD7-B090-1B2C03E6B4DB}" dt="2025-04-15T21:12:42.800" v="502" actId="14100"/>
          <ac:spMkLst>
            <pc:docMk/>
            <pc:sldMk cId="602764107" sldId="258"/>
            <ac:spMk id="49" creationId="{E017B100-5A11-0CC3-030C-73C9D87F3F29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50" creationId="{F1831A97-BE6B-6E10-334C-EB6674E1AF95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51" creationId="{A98D5731-9D18-45D8-0472-E69D4D114EBF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52" creationId="{32CFE93A-0981-A0DE-D5FD-9E3BA2E4955F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53" creationId="{BA9C3BCD-45FF-C8F2-6EF5-73FCAB566A85}"/>
          </ac:spMkLst>
        </pc:spChg>
        <pc:spChg chg="add mod">
          <ac:chgData name="FRANCESCA PAOLA NOCERA" userId="abafb519-3acb-45b6-b440-eaa72f2ef793" providerId="ADAL" clId="{45390E09-701E-4DD7-B090-1B2C03E6B4DB}" dt="2025-04-15T21:13:12.068" v="511" actId="14100"/>
          <ac:spMkLst>
            <pc:docMk/>
            <pc:sldMk cId="602764107" sldId="258"/>
            <ac:spMk id="54" creationId="{0F6B0CE6-FFD7-8ECF-6409-BE25D5AEC820}"/>
          </ac:spMkLst>
        </pc:spChg>
        <pc:spChg chg="add mod">
          <ac:chgData name="FRANCESCA PAOLA NOCERA" userId="abafb519-3acb-45b6-b440-eaa72f2ef793" providerId="ADAL" clId="{45390E09-701E-4DD7-B090-1B2C03E6B4DB}" dt="2025-04-15T21:13:16.413" v="512" actId="14100"/>
          <ac:spMkLst>
            <pc:docMk/>
            <pc:sldMk cId="602764107" sldId="258"/>
            <ac:spMk id="55" creationId="{541D44FF-3584-5F25-C69C-2BFBAD7CACE0}"/>
          </ac:spMkLst>
        </pc:spChg>
        <pc:spChg chg="add mod">
          <ac:chgData name="FRANCESCA PAOLA NOCERA" userId="abafb519-3acb-45b6-b440-eaa72f2ef793" providerId="ADAL" clId="{45390E09-701E-4DD7-B090-1B2C03E6B4DB}" dt="2025-04-15T21:13:41.651" v="513" actId="164"/>
          <ac:spMkLst>
            <pc:docMk/>
            <pc:sldMk cId="602764107" sldId="258"/>
            <ac:spMk id="56" creationId="{FDF85FED-C37F-B937-70F2-816412452DBA}"/>
          </ac:spMkLst>
        </pc:spChg>
        <pc:spChg chg="add mod">
          <ac:chgData name="FRANCESCA PAOLA NOCERA" userId="abafb519-3acb-45b6-b440-eaa72f2ef793" providerId="ADAL" clId="{45390E09-701E-4DD7-B090-1B2C03E6B4DB}" dt="2025-04-15T21:15:09.118" v="560" actId="164"/>
          <ac:spMkLst>
            <pc:docMk/>
            <pc:sldMk cId="602764107" sldId="258"/>
            <ac:spMk id="58" creationId="{C5E65008-BDE6-28F0-A288-9B7A4A7659F9}"/>
          </ac:spMkLst>
        </pc:spChg>
        <pc:grpChg chg="mod">
          <ac:chgData name="FRANCESCA PAOLA NOCERA" userId="abafb519-3acb-45b6-b440-eaa72f2ef793" providerId="ADAL" clId="{45390E09-701E-4DD7-B090-1B2C03E6B4DB}" dt="2025-04-15T21:44:59.491" v="562" actId="338"/>
          <ac:grpSpMkLst>
            <pc:docMk/>
            <pc:sldMk cId="602764107" sldId="258"/>
            <ac:grpSpMk id="22" creationId="{2F4927A3-2887-47D9-B282-85A1FB3D1ECE}"/>
          </ac:grpSpMkLst>
        </pc:grpChg>
        <pc:grpChg chg="mod">
          <ac:chgData name="FRANCESCA PAOLA NOCERA" userId="abafb519-3acb-45b6-b440-eaa72f2ef793" providerId="ADAL" clId="{45390E09-701E-4DD7-B090-1B2C03E6B4DB}" dt="2025-04-15T21:15:09.118" v="560" actId="164"/>
          <ac:grpSpMkLst>
            <pc:docMk/>
            <pc:sldMk cId="602764107" sldId="258"/>
            <ac:grpSpMk id="57" creationId="{441BFEDD-0025-489A-5A4C-D554459DAA25}"/>
          </ac:grpSpMkLst>
        </pc:grpChg>
        <pc:grpChg chg="add mod">
          <ac:chgData name="FRANCESCA PAOLA NOCERA" userId="abafb519-3acb-45b6-b440-eaa72f2ef793" providerId="ADAL" clId="{45390E09-701E-4DD7-B090-1B2C03E6B4DB}" dt="2025-04-15T21:15:09.118" v="560" actId="164"/>
          <ac:grpSpMkLst>
            <pc:docMk/>
            <pc:sldMk cId="602764107" sldId="258"/>
            <ac:grpSpMk id="59" creationId="{B1EDB50D-43F0-DAA5-DDC7-11854929337B}"/>
          </ac:grpSpMkLst>
        </pc:grpChg>
        <pc:picChg chg="add mod topLvl modCrop">
          <ac:chgData name="FRANCESCA PAOLA NOCERA" userId="abafb519-3acb-45b6-b440-eaa72f2ef793" providerId="ADAL" clId="{45390E09-701E-4DD7-B090-1B2C03E6B4DB}" dt="2025-04-15T21:47:33.441" v="564" actId="338"/>
          <ac:picMkLst>
            <pc:docMk/>
            <pc:sldMk cId="602764107" sldId="258"/>
            <ac:picMk id="25" creationId="{B99F3DB3-FEF2-3DFB-A7D5-30C9B9F85AB4}"/>
          </ac:picMkLst>
        </pc:picChg>
        <pc:picChg chg="add del mod modCrop">
          <ac:chgData name="FRANCESCA PAOLA NOCERA" userId="abafb519-3acb-45b6-b440-eaa72f2ef793" providerId="ADAL" clId="{45390E09-701E-4DD7-B090-1B2C03E6B4DB}" dt="2025-04-15T21:44:59.491" v="562" actId="338"/>
          <ac:picMkLst>
            <pc:docMk/>
            <pc:sldMk cId="602764107" sldId="258"/>
            <ac:picMk id="30" creationId="{6B8E75D7-0508-8632-26AB-36DFFBC3F3B4}"/>
          </ac:picMkLst>
        </pc:picChg>
        <pc:picChg chg="add mod modCrop">
          <ac:chgData name="FRANCESCA PAOLA NOCERA" userId="abafb519-3acb-45b6-b440-eaa72f2ef793" providerId="ADAL" clId="{45390E09-701E-4DD7-B090-1B2C03E6B4DB}" dt="2025-04-15T21:15:09.118" v="560" actId="164"/>
          <ac:picMkLst>
            <pc:docMk/>
            <pc:sldMk cId="602764107" sldId="258"/>
            <ac:picMk id="37" creationId="{22543ED5-EA24-CE7D-485A-19B423EAC543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47C630-E476-9D5D-46B1-D974A14B10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672ADBB-F339-ACCD-4142-5F79EA186C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9BBAE06-5DA0-324D-4536-BB9DE2BBB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9A48F58-E7C6-360F-370C-BB12BCA31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E9C419-CC18-3639-CAF2-FB5C6DAF3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614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3F3C12-E6DC-60FD-3464-844FB88A6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FFE65EF-D0DF-5786-232C-39FF61B331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795CC5-D4FB-1587-2B35-16B804054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37D1B8-C271-D614-2FD7-EED4EC8EE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63AB8A0-A35B-1EE7-ADE3-199E567E3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6070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1B3A71FB-2E94-994A-5810-DDFF2DC50B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A1E44C9-F1E8-F0F9-D9F8-6244412B59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6CFB4B6-AD33-FEE4-5370-8CE610D60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632B72A-DA12-1400-7F31-9CAE3A7CE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5D12EF1-E6B6-740C-3EEE-99CE01767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826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230BB9-5C0C-5341-489E-46F8BA1C0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C9925F9-A18F-5B43-3DEA-394588B3D1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AF7BD2-6A26-152B-38E6-47D6F7AD6D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4DF410C-93EF-5E91-ABAD-E55CA47FE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9857811-B732-99F1-A58B-771AF7CCC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0381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7304C80-1BB5-8866-62F5-F3016558A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CA0B563-4C84-C89A-A1E1-917C73905E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9983B9A-887A-92FA-AFC8-2F9E6C560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3560251-B2A1-7B88-384B-A3D2794EF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0D589EA-5DE3-1650-5F64-8A8EAD1C9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5384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90EC30-EBD6-E9A5-E2DF-EAC2FA779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10D986C-6E86-CB26-E0E3-5F3732C2C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A6B06D5-EBE9-560C-C252-992136570E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BA31D92-4073-1EE0-5CCE-0EC4FF0605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B5A1F45-6BBA-B6C5-E3C0-1E745202F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1E4A1FA-8971-124A-9473-C3196F8DE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1795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056F1B-77F5-6A2F-E710-D1FCBEBB7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D4267A5-080C-FDA1-7659-839E49C6D6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65F48DE-13C2-8C80-0348-C93B7F6893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C83096EA-14CF-11F8-542F-0DFC417907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4FCE9DD-2435-D95E-0BD8-66E3C02BE6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8FC75BE-2C01-F3C7-CED4-B089D625D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530EB9A-3ED7-4C4A-F6A9-CF6140CF0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39D2A1A-53D2-BDDE-08A5-6469EE56F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09108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AC29FF-7EEB-067C-CB44-1834C04AA9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9AA37CA-6101-447B-D26B-2F83FC777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96E5925-F6FB-24FA-5302-60F43E9CE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6794059-492C-04CE-F34A-C9C6D3625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090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257B0F9-E1D5-C5C9-55AA-455D62E513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3AD91EA8-9CEE-DD21-3804-7E6DBA100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2F23BAC-9DFB-9A67-F2F9-937CF5354B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9142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2F1511-C27A-A5DA-61DD-03F97EA0E3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F1E1098-41AF-664C-2945-8B446B1155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886DE25-1866-BAFB-8D09-B98E0F5147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6C88F7C-7528-215D-3115-7348F4192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138D658-7999-1818-4ECB-73670889B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F332B56-0AE1-DEC7-DE46-1072913E2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496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6A76F5D-5029-275F-CB97-2B0188AD7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8BFEBF3-99FE-190E-A6E0-89E63B4BC2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0CBA4A7-8E79-FFBB-829C-41A29CA83B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0EA91C3-3A00-E3F5-28E9-800899BF8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247C4FF-79DC-FCD6-FD7B-3300C4608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B2FA9C0-D7D6-22D1-CABB-9AC69DF41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976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BC57F5D-1FFD-1311-40C2-385D48D15F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942EB3D-B090-F79E-7EC7-EA89425219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AF0AA22-0B4C-ADB7-2D36-324139BE09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39A1F57-3CF9-4BAF-A719-7DB6D6F26580}" type="datetimeFigureOut">
              <a:rPr lang="it-IT" smtClean="0"/>
              <a:t>29/04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5CDBB4B-1894-CB3F-D11E-2B956A465E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8E73722-A08A-8E96-3F4A-AFDD3B4B16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6CB412-FE68-49FA-AE36-4A351945BF5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6407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171A3D78-D406-FFDA-F09D-644FB81762CA}"/>
              </a:ext>
            </a:extLst>
          </p:cNvPr>
          <p:cNvGrpSpPr/>
          <p:nvPr/>
        </p:nvGrpSpPr>
        <p:grpSpPr>
          <a:xfrm>
            <a:off x="3052396" y="334773"/>
            <a:ext cx="7082204" cy="4527292"/>
            <a:chOff x="-899381" y="456920"/>
            <a:chExt cx="6376587" cy="4336840"/>
          </a:xfrm>
        </p:grpSpPr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251519C4-9082-3F4E-BFB0-FC56ADC603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30246" y="456920"/>
              <a:ext cx="3176291" cy="3493311"/>
            </a:xfrm>
            <a:prstGeom prst="rect">
              <a:avLst/>
            </a:prstGeom>
          </p:spPr>
        </p:pic>
        <p:grpSp>
          <p:nvGrpSpPr>
            <p:cNvPr id="11" name="Gruppo 10">
              <a:extLst>
                <a:ext uri="{FF2B5EF4-FFF2-40B4-BE49-F238E27FC236}">
                  <a16:creationId xmlns:a16="http://schemas.microsoft.com/office/drawing/2014/main" id="{1C023F2E-2640-24BC-AECE-B602E24F0382}"/>
                </a:ext>
              </a:extLst>
            </p:cNvPr>
            <p:cNvGrpSpPr/>
            <p:nvPr/>
          </p:nvGrpSpPr>
          <p:grpSpPr>
            <a:xfrm>
              <a:off x="697856" y="495802"/>
              <a:ext cx="3143632" cy="257108"/>
              <a:chOff x="697856" y="495802"/>
              <a:chExt cx="3143632" cy="257108"/>
            </a:xfrm>
          </p:grpSpPr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53C8AF57-04FF-7EEB-F350-1821C967D754}"/>
                  </a:ext>
                </a:extLst>
              </p:cNvPr>
              <p:cNvSpPr txBox="1"/>
              <p:nvPr/>
            </p:nvSpPr>
            <p:spPr>
              <a:xfrm>
                <a:off x="697856" y="506689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4" name="CasellaDiTesto 3">
                <a:extLst>
                  <a:ext uri="{FF2B5EF4-FFF2-40B4-BE49-F238E27FC236}">
                    <a16:creationId xmlns:a16="http://schemas.microsoft.com/office/drawing/2014/main" id="{02EFD1C4-B327-6AB8-362A-73BAFAD4CA47}"/>
                  </a:ext>
                </a:extLst>
              </p:cNvPr>
              <p:cNvSpPr txBox="1"/>
              <p:nvPr/>
            </p:nvSpPr>
            <p:spPr>
              <a:xfrm>
                <a:off x="1121231" y="506689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866307CC-A97F-7DB0-C0B7-2961ABD9CFE5}"/>
                  </a:ext>
                </a:extLst>
              </p:cNvPr>
              <p:cNvSpPr txBox="1"/>
              <p:nvPr/>
            </p:nvSpPr>
            <p:spPr>
              <a:xfrm>
                <a:off x="2482034" y="495803"/>
                <a:ext cx="56488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93359F8E-56DE-F0EE-4843-E74977EEBB0A}"/>
                  </a:ext>
                </a:extLst>
              </p:cNvPr>
              <p:cNvSpPr txBox="1"/>
              <p:nvPr/>
            </p:nvSpPr>
            <p:spPr>
              <a:xfrm>
                <a:off x="1545772" y="506517"/>
                <a:ext cx="5648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92FA545E-CDDA-183B-3111-DD1AFE3BD030}"/>
                  </a:ext>
                </a:extLst>
              </p:cNvPr>
              <p:cNvSpPr txBox="1"/>
              <p:nvPr/>
            </p:nvSpPr>
            <p:spPr>
              <a:xfrm>
                <a:off x="2014534" y="495803"/>
                <a:ext cx="516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5A3D8B0C-A089-7C13-82AB-DA2D0AC719A0}"/>
                  </a:ext>
                </a:extLst>
              </p:cNvPr>
              <p:cNvSpPr txBox="1"/>
              <p:nvPr/>
            </p:nvSpPr>
            <p:spPr>
              <a:xfrm>
                <a:off x="2878777" y="495802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B1C7C599-CC3F-5734-F4B8-58C3272378A0}"/>
                  </a:ext>
                </a:extLst>
              </p:cNvPr>
              <p:cNvSpPr txBox="1"/>
              <p:nvPr/>
            </p:nvSpPr>
            <p:spPr>
              <a:xfrm>
                <a:off x="3350463" y="506517"/>
                <a:ext cx="4910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-</a:t>
                </a:r>
              </a:p>
            </p:txBody>
          </p:sp>
        </p:grp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8D874BF5-681C-9926-A09D-16E50DE29FD0}"/>
                </a:ext>
              </a:extLst>
            </p:cNvPr>
            <p:cNvSpPr txBox="1"/>
            <p:nvPr/>
          </p:nvSpPr>
          <p:spPr>
            <a:xfrm>
              <a:off x="-899381" y="4174619"/>
              <a:ext cx="6376587" cy="619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 S1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bla</a:t>
              </a:r>
              <a:r>
                <a:rPr lang="en-US" sz="1200" b="1" i="1" baseline="-25000" dirty="0" err="1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SHV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</a:p>
            <a:p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8, 9, 10, 11, 17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M, 100-bp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 negative control (</a:t>
              </a:r>
              <a:r>
                <a:rPr lang="it-IT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s aeruginosa 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CC® 27853)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6604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83C96A-0F73-A1DD-B9D4-825F4F4693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uppo 55">
            <a:extLst>
              <a:ext uri="{FF2B5EF4-FFF2-40B4-BE49-F238E27FC236}">
                <a16:creationId xmlns:a16="http://schemas.microsoft.com/office/drawing/2014/main" id="{A39269F9-04BF-C21A-585E-C8814E7D03F6}"/>
              </a:ext>
            </a:extLst>
          </p:cNvPr>
          <p:cNvGrpSpPr/>
          <p:nvPr/>
        </p:nvGrpSpPr>
        <p:grpSpPr>
          <a:xfrm>
            <a:off x="3320142" y="1784827"/>
            <a:ext cx="6270172" cy="2809174"/>
            <a:chOff x="8036477" y="751864"/>
            <a:chExt cx="4930219" cy="2779053"/>
          </a:xfrm>
        </p:grpSpPr>
        <p:pic>
          <p:nvPicPr>
            <p:cNvPr id="48" name="Immagine 47" descr="Immagine che contiene schermata, Policromia, Rettangolo, violetto&#10;&#10;Il contenuto generato dall'IA potrebbe non essere corretto.">
              <a:extLst>
                <a:ext uri="{FF2B5EF4-FFF2-40B4-BE49-F238E27FC236}">
                  <a16:creationId xmlns:a16="http://schemas.microsoft.com/office/drawing/2014/main" id="{2195024C-D74D-FE39-960E-8E3FC3A32E7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724" t="38890" r="18691" b="44872"/>
            <a:stretch/>
          </p:blipFill>
          <p:spPr>
            <a:xfrm>
              <a:off x="8811607" y="751864"/>
              <a:ext cx="2813554" cy="1685476"/>
            </a:xfrm>
            <a:prstGeom prst="rect">
              <a:avLst/>
            </a:prstGeom>
          </p:spPr>
        </p:pic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ABCFA0E4-BBDE-BEA0-BC0B-6CDA7EFFA2B3}"/>
                </a:ext>
              </a:extLst>
            </p:cNvPr>
            <p:cNvSpPr txBox="1"/>
            <p:nvPr/>
          </p:nvSpPr>
          <p:spPr>
            <a:xfrm>
              <a:off x="8991671" y="961663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165A0A1C-6832-04A4-916A-FCD625AF87BD}"/>
                </a:ext>
              </a:extLst>
            </p:cNvPr>
            <p:cNvSpPr txBox="1"/>
            <p:nvPr/>
          </p:nvSpPr>
          <p:spPr>
            <a:xfrm>
              <a:off x="9311437" y="961662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13434EA1-7BA2-81CE-5194-5424CEE127AB}"/>
                </a:ext>
              </a:extLst>
            </p:cNvPr>
            <p:cNvSpPr txBox="1"/>
            <p:nvPr/>
          </p:nvSpPr>
          <p:spPr>
            <a:xfrm>
              <a:off x="9631203" y="961661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8C57929B-C501-3227-BCA6-C167D9466A62}"/>
                </a:ext>
              </a:extLst>
            </p:cNvPr>
            <p:cNvSpPr txBox="1"/>
            <p:nvPr/>
          </p:nvSpPr>
          <p:spPr>
            <a:xfrm>
              <a:off x="9880890" y="961660"/>
              <a:ext cx="3397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E9D0FE90-02E1-C0D5-4767-69A0402CA55B}"/>
                </a:ext>
              </a:extLst>
            </p:cNvPr>
            <p:cNvSpPr txBox="1"/>
            <p:nvPr/>
          </p:nvSpPr>
          <p:spPr>
            <a:xfrm>
              <a:off x="10206579" y="961659"/>
              <a:ext cx="4910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-</a:t>
              </a:r>
            </a:p>
          </p:txBody>
        </p:sp>
        <p:sp>
          <p:nvSpPr>
            <p:cNvPr id="54" name="CasellaDiTesto 53">
              <a:extLst>
                <a:ext uri="{FF2B5EF4-FFF2-40B4-BE49-F238E27FC236}">
                  <a16:creationId xmlns:a16="http://schemas.microsoft.com/office/drawing/2014/main" id="{7E4BC6BB-198C-3EFD-169A-2CABEAD79FC6}"/>
                </a:ext>
              </a:extLst>
            </p:cNvPr>
            <p:cNvSpPr txBox="1"/>
            <p:nvPr/>
          </p:nvSpPr>
          <p:spPr>
            <a:xfrm>
              <a:off x="10518381" y="945174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55" name="CasellaDiTesto 54">
              <a:extLst>
                <a:ext uri="{FF2B5EF4-FFF2-40B4-BE49-F238E27FC236}">
                  <a16:creationId xmlns:a16="http://schemas.microsoft.com/office/drawing/2014/main" id="{38F7D2CC-39FC-9252-9AC7-A2052353A348}"/>
                </a:ext>
              </a:extLst>
            </p:cNvPr>
            <p:cNvSpPr txBox="1"/>
            <p:nvPr/>
          </p:nvSpPr>
          <p:spPr>
            <a:xfrm>
              <a:off x="8036477" y="2891516"/>
              <a:ext cx="4930219" cy="639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bla</a:t>
              </a:r>
              <a:r>
                <a:rPr lang="en-US" sz="1200" b="1" i="1" baseline="-25000" dirty="0" err="1">
                  <a:latin typeface="Times New Roman" panose="02020603050405020304" pitchFamily="18" charset="0"/>
                  <a:ea typeface="Aptos" panose="020B0004020202020204" pitchFamily="34" charset="0"/>
                </a:rPr>
                <a:t>TEM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3, 4, 6, 14,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 negative control (</a:t>
              </a:r>
              <a:r>
                <a:rPr lang="it-IT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s aeruginosa 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CC® 27853); lane M, 100-bp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93891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E6CB86-1049-ED53-32C9-95626DE36D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o 23">
            <a:extLst>
              <a:ext uri="{FF2B5EF4-FFF2-40B4-BE49-F238E27FC236}">
                <a16:creationId xmlns:a16="http://schemas.microsoft.com/office/drawing/2014/main" id="{4996B0A4-1B96-ED3C-ADAB-1AE098CDFFBD}"/>
              </a:ext>
            </a:extLst>
          </p:cNvPr>
          <p:cNvGrpSpPr/>
          <p:nvPr/>
        </p:nvGrpSpPr>
        <p:grpSpPr>
          <a:xfrm>
            <a:off x="3187732" y="1396808"/>
            <a:ext cx="6270170" cy="2907574"/>
            <a:chOff x="4059076" y="481788"/>
            <a:chExt cx="5097402" cy="2863792"/>
          </a:xfrm>
        </p:grpSpPr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817DA755-BEB0-9077-C203-C9BF147A55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4437" b="40056"/>
            <a:stretch/>
          </p:blipFill>
          <p:spPr bwMode="auto">
            <a:xfrm>
              <a:off x="4660931" y="506517"/>
              <a:ext cx="3595370" cy="203835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B92E308A-CC14-C4D5-9633-EA069AB1ABFC}"/>
                </a:ext>
              </a:extLst>
            </p:cNvPr>
            <p:cNvSpPr txBox="1"/>
            <p:nvPr/>
          </p:nvSpPr>
          <p:spPr>
            <a:xfrm>
              <a:off x="4059076" y="2708981"/>
              <a:ext cx="5097402" cy="6365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3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bla</a:t>
              </a:r>
              <a:r>
                <a:rPr lang="en-US" sz="1200" b="1" i="1" baseline="-25000" dirty="0" err="1">
                  <a:effectLst/>
                  <a:latin typeface="Times New Roman" panose="02020603050405020304" pitchFamily="18" charset="0"/>
                  <a:ea typeface="Aptos" panose="020B0004020202020204" pitchFamily="34" charset="0"/>
                </a:rPr>
                <a:t>G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, 2, 3, 4, 5, 6, 7, 8, 9, 10, 13, 16, 17,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M, 100-bp plus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 negative control (</a:t>
              </a:r>
              <a:r>
                <a:rPr lang="it-IT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seudomonas aeruginosa 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CC® 27853). </a:t>
              </a:r>
            </a:p>
          </p:txBody>
        </p:sp>
        <p:grpSp>
          <p:nvGrpSpPr>
            <p:cNvPr id="41" name="Gruppo 40">
              <a:extLst>
                <a:ext uri="{FF2B5EF4-FFF2-40B4-BE49-F238E27FC236}">
                  <a16:creationId xmlns:a16="http://schemas.microsoft.com/office/drawing/2014/main" id="{D69DF4AA-FE18-6D59-D6FF-2E5594A170FF}"/>
                </a:ext>
              </a:extLst>
            </p:cNvPr>
            <p:cNvGrpSpPr/>
            <p:nvPr/>
          </p:nvGrpSpPr>
          <p:grpSpPr>
            <a:xfrm>
              <a:off x="4644401" y="481788"/>
              <a:ext cx="3847440" cy="270950"/>
              <a:chOff x="4644401" y="481788"/>
              <a:chExt cx="3847440" cy="270950"/>
            </a:xfrm>
          </p:grpSpPr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B26A4CB4-7939-A3FD-9B45-31426626B057}"/>
                  </a:ext>
                </a:extLst>
              </p:cNvPr>
              <p:cNvSpPr txBox="1"/>
              <p:nvPr/>
            </p:nvSpPr>
            <p:spPr>
              <a:xfrm>
                <a:off x="4644401" y="50651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E361FB78-3668-E578-E42D-F7F4816498C8}"/>
                  </a:ext>
                </a:extLst>
              </p:cNvPr>
              <p:cNvSpPr txBox="1"/>
              <p:nvPr/>
            </p:nvSpPr>
            <p:spPr>
              <a:xfrm>
                <a:off x="4896907" y="495801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44BFB0B6-0393-AD2F-C148-27E78907F80D}"/>
                  </a:ext>
                </a:extLst>
              </p:cNvPr>
              <p:cNvSpPr txBox="1"/>
              <p:nvPr/>
            </p:nvSpPr>
            <p:spPr>
              <a:xfrm>
                <a:off x="5119863" y="495801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21F5F048-0226-122D-22D6-C2185BB3B7EB}"/>
                  </a:ext>
                </a:extLst>
              </p:cNvPr>
              <p:cNvSpPr txBox="1"/>
              <p:nvPr/>
            </p:nvSpPr>
            <p:spPr>
              <a:xfrm>
                <a:off x="5363333" y="50651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4B49A2EE-8C2E-F191-9FB3-DC9E3F6D6CBB}"/>
                  </a:ext>
                </a:extLst>
              </p:cNvPr>
              <p:cNvSpPr txBox="1"/>
              <p:nvPr/>
            </p:nvSpPr>
            <p:spPr>
              <a:xfrm>
                <a:off x="5619257" y="50651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7CD9A541-B76B-719F-6B2D-99B2A99A1DDB}"/>
                  </a:ext>
                </a:extLst>
              </p:cNvPr>
              <p:cNvSpPr txBox="1"/>
              <p:nvPr/>
            </p:nvSpPr>
            <p:spPr>
              <a:xfrm>
                <a:off x="5871675" y="49580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902A2886-D6D4-4DCF-717D-94C1FC2AEE67}"/>
                  </a:ext>
                </a:extLst>
              </p:cNvPr>
              <p:cNvSpPr txBox="1"/>
              <p:nvPr/>
            </p:nvSpPr>
            <p:spPr>
              <a:xfrm>
                <a:off x="6096000" y="50651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5A48BE09-09D9-D052-1387-87F4AAF12517}"/>
                  </a:ext>
                </a:extLst>
              </p:cNvPr>
              <p:cNvSpPr txBox="1"/>
              <p:nvPr/>
            </p:nvSpPr>
            <p:spPr>
              <a:xfrm>
                <a:off x="6368291" y="49580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1164CBCD-0660-F129-EB23-1B0768B81968}"/>
                  </a:ext>
                </a:extLst>
              </p:cNvPr>
              <p:cNvSpPr txBox="1"/>
              <p:nvPr/>
            </p:nvSpPr>
            <p:spPr>
              <a:xfrm>
                <a:off x="6639066" y="495799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66A49962-3D6F-93B3-5B47-4436017EC4F8}"/>
                  </a:ext>
                </a:extLst>
              </p:cNvPr>
              <p:cNvSpPr txBox="1"/>
              <p:nvPr/>
            </p:nvSpPr>
            <p:spPr>
              <a:xfrm>
                <a:off x="6833603" y="495798"/>
                <a:ext cx="356996" cy="244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6FF7CDFE-CB39-0E75-8ACD-44DB3E465B36}"/>
                  </a:ext>
                </a:extLst>
              </p:cNvPr>
              <p:cNvSpPr txBox="1"/>
              <p:nvPr/>
            </p:nvSpPr>
            <p:spPr>
              <a:xfrm>
                <a:off x="7596478" y="495796"/>
                <a:ext cx="315194" cy="244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</p:txBody>
          </p:sp>
          <p:sp>
            <p:nvSpPr>
              <p:cNvPr id="27" name="CasellaDiTesto 26">
                <a:extLst>
                  <a:ext uri="{FF2B5EF4-FFF2-40B4-BE49-F238E27FC236}">
                    <a16:creationId xmlns:a16="http://schemas.microsoft.com/office/drawing/2014/main" id="{AB0BB17F-F79A-221A-63A1-AC9DE62E2875}"/>
                  </a:ext>
                </a:extLst>
              </p:cNvPr>
              <p:cNvSpPr txBox="1"/>
              <p:nvPr/>
            </p:nvSpPr>
            <p:spPr>
              <a:xfrm>
                <a:off x="7795533" y="494052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28" name="CasellaDiTesto 27">
                <a:extLst>
                  <a:ext uri="{FF2B5EF4-FFF2-40B4-BE49-F238E27FC236}">
                    <a16:creationId xmlns:a16="http://schemas.microsoft.com/office/drawing/2014/main" id="{E9A3CCDE-7299-B848-F85F-948875E766E8}"/>
                  </a:ext>
                </a:extLst>
              </p:cNvPr>
              <p:cNvSpPr txBox="1"/>
              <p:nvPr/>
            </p:nvSpPr>
            <p:spPr>
              <a:xfrm>
                <a:off x="8000816" y="506517"/>
                <a:ext cx="4910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-</a:t>
                </a:r>
              </a:p>
            </p:txBody>
          </p:sp>
          <p:sp>
            <p:nvSpPr>
              <p:cNvPr id="29" name="CasellaDiTesto 28">
                <a:extLst>
                  <a:ext uri="{FF2B5EF4-FFF2-40B4-BE49-F238E27FC236}">
                    <a16:creationId xmlns:a16="http://schemas.microsoft.com/office/drawing/2014/main" id="{013B508A-FB3D-9699-1E76-91086CE6F69D}"/>
                  </a:ext>
                </a:extLst>
              </p:cNvPr>
              <p:cNvSpPr txBox="1"/>
              <p:nvPr/>
            </p:nvSpPr>
            <p:spPr>
              <a:xfrm>
                <a:off x="7084701" y="507389"/>
                <a:ext cx="356996" cy="2444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</a:p>
            </p:txBody>
          </p:sp>
          <p:sp>
            <p:nvSpPr>
              <p:cNvPr id="37" name="CasellaDiTesto 36">
                <a:extLst>
                  <a:ext uri="{FF2B5EF4-FFF2-40B4-BE49-F238E27FC236}">
                    <a16:creationId xmlns:a16="http://schemas.microsoft.com/office/drawing/2014/main" id="{A5575017-D6D8-0086-8877-0CB9B6096795}"/>
                  </a:ext>
                </a:extLst>
              </p:cNvPr>
              <p:cNvSpPr txBox="1"/>
              <p:nvPr/>
            </p:nvSpPr>
            <p:spPr>
              <a:xfrm>
                <a:off x="7345380" y="481788"/>
                <a:ext cx="35699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58656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Gruppo 58">
            <a:extLst>
              <a:ext uri="{FF2B5EF4-FFF2-40B4-BE49-F238E27FC236}">
                <a16:creationId xmlns:a16="http://schemas.microsoft.com/office/drawing/2014/main" id="{B1EDB50D-43F0-DAA5-DDC7-11854929337B}"/>
              </a:ext>
            </a:extLst>
          </p:cNvPr>
          <p:cNvGrpSpPr/>
          <p:nvPr/>
        </p:nvGrpSpPr>
        <p:grpSpPr>
          <a:xfrm>
            <a:off x="3207066" y="1668168"/>
            <a:ext cx="6087289" cy="2461887"/>
            <a:chOff x="5252622" y="3976577"/>
            <a:chExt cx="6087289" cy="2461887"/>
          </a:xfrm>
        </p:grpSpPr>
        <p:pic>
          <p:nvPicPr>
            <p:cNvPr id="37" name="Immagine 36" descr="Immagine che contiene schermata, violetto, viola, blu&#10;&#10;Il contenuto generato dall'IA potrebbe non essere corretto.">
              <a:extLst>
                <a:ext uri="{FF2B5EF4-FFF2-40B4-BE49-F238E27FC236}">
                  <a16:creationId xmlns:a16="http://schemas.microsoft.com/office/drawing/2014/main" id="{22543ED5-EA24-CE7D-485A-19B423EAC5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74" t="43563" b="2446"/>
            <a:stretch/>
          </p:blipFill>
          <p:spPr>
            <a:xfrm>
              <a:off x="5634274" y="3976577"/>
              <a:ext cx="5210507" cy="1743364"/>
            </a:xfrm>
            <a:prstGeom prst="rect">
              <a:avLst/>
            </a:prstGeom>
          </p:spPr>
        </p:pic>
        <p:grpSp>
          <p:nvGrpSpPr>
            <p:cNvPr id="57" name="Gruppo 56">
              <a:extLst>
                <a:ext uri="{FF2B5EF4-FFF2-40B4-BE49-F238E27FC236}">
                  <a16:creationId xmlns:a16="http://schemas.microsoft.com/office/drawing/2014/main" id="{441BFEDD-0025-489A-5A4C-D554459DAA25}"/>
                </a:ext>
              </a:extLst>
            </p:cNvPr>
            <p:cNvGrpSpPr/>
            <p:nvPr/>
          </p:nvGrpSpPr>
          <p:grpSpPr>
            <a:xfrm>
              <a:off x="5912839" y="4036673"/>
              <a:ext cx="4945796" cy="299168"/>
              <a:chOff x="5912839" y="4036673"/>
              <a:chExt cx="4945796" cy="299168"/>
            </a:xfrm>
          </p:grpSpPr>
          <p:sp>
            <p:nvSpPr>
              <p:cNvPr id="38" name="CasellaDiTesto 37">
                <a:extLst>
                  <a:ext uri="{FF2B5EF4-FFF2-40B4-BE49-F238E27FC236}">
                    <a16:creationId xmlns:a16="http://schemas.microsoft.com/office/drawing/2014/main" id="{42A947BC-D2FD-99FA-94FD-E3A5A0EE005E}"/>
                  </a:ext>
                </a:extLst>
              </p:cNvPr>
              <p:cNvSpPr txBox="1"/>
              <p:nvPr/>
            </p:nvSpPr>
            <p:spPr>
              <a:xfrm>
                <a:off x="5912839" y="408962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39" name="CasellaDiTesto 38">
                <a:extLst>
                  <a:ext uri="{FF2B5EF4-FFF2-40B4-BE49-F238E27FC236}">
                    <a16:creationId xmlns:a16="http://schemas.microsoft.com/office/drawing/2014/main" id="{18F6406B-A305-00B3-2601-4D8408D36473}"/>
                  </a:ext>
                </a:extLst>
              </p:cNvPr>
              <p:cNvSpPr txBox="1"/>
              <p:nvPr/>
            </p:nvSpPr>
            <p:spPr>
              <a:xfrm>
                <a:off x="6152325" y="408962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3E116D43-FB23-D72B-FA76-A0F740CC6FBE}"/>
                  </a:ext>
                </a:extLst>
              </p:cNvPr>
              <p:cNvSpPr txBox="1"/>
              <p:nvPr/>
            </p:nvSpPr>
            <p:spPr>
              <a:xfrm>
                <a:off x="6430890" y="408962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AA442CA6-75A0-D358-0B80-E1DA7C893CAC}"/>
                  </a:ext>
                </a:extLst>
              </p:cNvPr>
              <p:cNvSpPr txBox="1"/>
              <p:nvPr/>
            </p:nvSpPr>
            <p:spPr>
              <a:xfrm>
                <a:off x="6709455" y="4089619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42" name="CasellaDiTesto 41">
                <a:extLst>
                  <a:ext uri="{FF2B5EF4-FFF2-40B4-BE49-F238E27FC236}">
                    <a16:creationId xmlns:a16="http://schemas.microsoft.com/office/drawing/2014/main" id="{7D7A61AE-7540-AEE3-4016-06112E70ED32}"/>
                  </a:ext>
                </a:extLst>
              </p:cNvPr>
              <p:cNvSpPr txBox="1"/>
              <p:nvPr/>
            </p:nvSpPr>
            <p:spPr>
              <a:xfrm>
                <a:off x="6988020" y="4089618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43" name="CasellaDiTesto 42">
                <a:extLst>
                  <a:ext uri="{FF2B5EF4-FFF2-40B4-BE49-F238E27FC236}">
                    <a16:creationId xmlns:a16="http://schemas.microsoft.com/office/drawing/2014/main" id="{7F084E0C-AE58-6260-37FC-C1FDCB3C058A}"/>
                  </a:ext>
                </a:extLst>
              </p:cNvPr>
              <p:cNvSpPr txBox="1"/>
              <p:nvPr/>
            </p:nvSpPr>
            <p:spPr>
              <a:xfrm>
                <a:off x="7227506" y="408961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45" name="CasellaDiTesto 44">
                <a:extLst>
                  <a:ext uri="{FF2B5EF4-FFF2-40B4-BE49-F238E27FC236}">
                    <a16:creationId xmlns:a16="http://schemas.microsoft.com/office/drawing/2014/main" id="{BFAAF74B-06AF-46EB-4B2F-6B7A73E18A34}"/>
                  </a:ext>
                </a:extLst>
              </p:cNvPr>
              <p:cNvSpPr txBox="1"/>
              <p:nvPr/>
            </p:nvSpPr>
            <p:spPr>
              <a:xfrm>
                <a:off x="7815518" y="4089615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46" name="CasellaDiTesto 45">
                <a:extLst>
                  <a:ext uri="{FF2B5EF4-FFF2-40B4-BE49-F238E27FC236}">
                    <a16:creationId xmlns:a16="http://schemas.microsoft.com/office/drawing/2014/main" id="{1CE4655E-C248-574E-AB01-99903F56E284}"/>
                  </a:ext>
                </a:extLst>
              </p:cNvPr>
              <p:cNvSpPr txBox="1"/>
              <p:nvPr/>
            </p:nvSpPr>
            <p:spPr>
              <a:xfrm>
                <a:off x="8042927" y="4089614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47" name="CasellaDiTesto 46">
                <a:extLst>
                  <a:ext uri="{FF2B5EF4-FFF2-40B4-BE49-F238E27FC236}">
                    <a16:creationId xmlns:a16="http://schemas.microsoft.com/office/drawing/2014/main" id="{37FC8BBB-A80E-0A74-94CC-86EDA4EA16F2}"/>
                  </a:ext>
                </a:extLst>
              </p:cNvPr>
              <p:cNvSpPr txBox="1"/>
              <p:nvPr/>
            </p:nvSpPr>
            <p:spPr>
              <a:xfrm>
                <a:off x="8296267" y="405018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48" name="CasellaDiTesto 47">
                <a:extLst>
                  <a:ext uri="{FF2B5EF4-FFF2-40B4-BE49-F238E27FC236}">
                    <a16:creationId xmlns:a16="http://schemas.microsoft.com/office/drawing/2014/main" id="{82A76890-05EC-1932-329B-31DEC10746F0}"/>
                  </a:ext>
                </a:extLst>
              </p:cNvPr>
              <p:cNvSpPr txBox="1"/>
              <p:nvPr/>
            </p:nvSpPr>
            <p:spPr>
              <a:xfrm>
                <a:off x="8493619" y="4050186"/>
                <a:ext cx="3206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49" name="CasellaDiTesto 48">
                <a:extLst>
                  <a:ext uri="{FF2B5EF4-FFF2-40B4-BE49-F238E27FC236}">
                    <a16:creationId xmlns:a16="http://schemas.microsoft.com/office/drawing/2014/main" id="{E017B100-5A11-0CC3-030C-73C9D87F3F29}"/>
                  </a:ext>
                </a:extLst>
              </p:cNvPr>
              <p:cNvSpPr txBox="1"/>
              <p:nvPr/>
            </p:nvSpPr>
            <p:spPr>
              <a:xfrm>
                <a:off x="8774995" y="4050186"/>
                <a:ext cx="3114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</a:t>
                </a:r>
              </a:p>
            </p:txBody>
          </p:sp>
          <p:sp>
            <p:nvSpPr>
              <p:cNvPr id="50" name="CasellaDiTesto 49">
                <a:extLst>
                  <a:ext uri="{FF2B5EF4-FFF2-40B4-BE49-F238E27FC236}">
                    <a16:creationId xmlns:a16="http://schemas.microsoft.com/office/drawing/2014/main" id="{F1831A97-BE6B-6E10-334C-EB6674E1AF95}"/>
                  </a:ext>
                </a:extLst>
              </p:cNvPr>
              <p:cNvSpPr txBox="1"/>
              <p:nvPr/>
            </p:nvSpPr>
            <p:spPr>
              <a:xfrm>
                <a:off x="9040172" y="4050185"/>
                <a:ext cx="33513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</a:p>
            </p:txBody>
          </p:sp>
          <p:sp>
            <p:nvSpPr>
              <p:cNvPr id="51" name="CasellaDiTesto 50">
                <a:extLst>
                  <a:ext uri="{FF2B5EF4-FFF2-40B4-BE49-F238E27FC236}">
                    <a16:creationId xmlns:a16="http://schemas.microsoft.com/office/drawing/2014/main" id="{A98D5731-9D18-45D8-0472-E69D4D114EBF}"/>
                  </a:ext>
                </a:extLst>
              </p:cNvPr>
              <p:cNvSpPr txBox="1"/>
              <p:nvPr/>
            </p:nvSpPr>
            <p:spPr>
              <a:xfrm>
                <a:off x="9358608" y="4050184"/>
                <a:ext cx="3206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</a:p>
            </p:txBody>
          </p:sp>
          <p:sp>
            <p:nvSpPr>
              <p:cNvPr id="52" name="CasellaDiTesto 51">
                <a:extLst>
                  <a:ext uri="{FF2B5EF4-FFF2-40B4-BE49-F238E27FC236}">
                    <a16:creationId xmlns:a16="http://schemas.microsoft.com/office/drawing/2014/main" id="{32CFE93A-0981-A0DE-D5FD-9E3BA2E4955F}"/>
                  </a:ext>
                </a:extLst>
              </p:cNvPr>
              <p:cNvSpPr txBox="1"/>
              <p:nvPr/>
            </p:nvSpPr>
            <p:spPr>
              <a:xfrm>
                <a:off x="9648016" y="4050183"/>
                <a:ext cx="34550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</a:p>
            </p:txBody>
          </p:sp>
          <p:sp>
            <p:nvSpPr>
              <p:cNvPr id="53" name="CasellaDiTesto 52">
                <a:extLst>
                  <a:ext uri="{FF2B5EF4-FFF2-40B4-BE49-F238E27FC236}">
                    <a16:creationId xmlns:a16="http://schemas.microsoft.com/office/drawing/2014/main" id="{BA9C3BCD-45FF-C8F2-6EF5-73FCAB566A85}"/>
                  </a:ext>
                </a:extLst>
              </p:cNvPr>
              <p:cNvSpPr txBox="1"/>
              <p:nvPr/>
            </p:nvSpPr>
            <p:spPr>
              <a:xfrm>
                <a:off x="9949017" y="4050183"/>
                <a:ext cx="3470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</a:p>
            </p:txBody>
          </p:sp>
          <p:sp>
            <p:nvSpPr>
              <p:cNvPr id="54" name="CasellaDiTesto 53">
                <a:extLst>
                  <a:ext uri="{FF2B5EF4-FFF2-40B4-BE49-F238E27FC236}">
                    <a16:creationId xmlns:a16="http://schemas.microsoft.com/office/drawing/2014/main" id="{0F6B0CE6-FFD7-8ECF-6409-BE25D5AEC820}"/>
                  </a:ext>
                </a:extLst>
              </p:cNvPr>
              <p:cNvSpPr txBox="1"/>
              <p:nvPr/>
            </p:nvSpPr>
            <p:spPr>
              <a:xfrm>
                <a:off x="10216542" y="4036673"/>
                <a:ext cx="34550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</p:txBody>
          </p:sp>
          <p:sp>
            <p:nvSpPr>
              <p:cNvPr id="55" name="CasellaDiTesto 54">
                <a:extLst>
                  <a:ext uri="{FF2B5EF4-FFF2-40B4-BE49-F238E27FC236}">
                    <a16:creationId xmlns:a16="http://schemas.microsoft.com/office/drawing/2014/main" id="{541D44FF-3584-5F25-C69C-2BFBAD7CACE0}"/>
                  </a:ext>
                </a:extLst>
              </p:cNvPr>
              <p:cNvSpPr txBox="1"/>
              <p:nvPr/>
            </p:nvSpPr>
            <p:spPr>
              <a:xfrm>
                <a:off x="10514635" y="4050182"/>
                <a:ext cx="3440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-</a:t>
                </a:r>
              </a:p>
            </p:txBody>
          </p:sp>
          <p:sp>
            <p:nvSpPr>
              <p:cNvPr id="56" name="CasellaDiTesto 55">
                <a:extLst>
                  <a:ext uri="{FF2B5EF4-FFF2-40B4-BE49-F238E27FC236}">
                    <a16:creationId xmlns:a16="http://schemas.microsoft.com/office/drawing/2014/main" id="{FDF85FED-C37F-B937-70F2-816412452DBA}"/>
                  </a:ext>
                </a:extLst>
              </p:cNvPr>
              <p:cNvSpPr txBox="1"/>
              <p:nvPr/>
            </p:nvSpPr>
            <p:spPr>
              <a:xfrm>
                <a:off x="7518473" y="4089613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</a:p>
            </p:txBody>
          </p:sp>
        </p:grp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C5E65008-BDE6-28F0-A288-9B7A4A7659F9}"/>
                </a:ext>
              </a:extLst>
            </p:cNvPr>
            <p:cNvSpPr txBox="1"/>
            <p:nvPr/>
          </p:nvSpPr>
          <p:spPr>
            <a:xfrm>
              <a:off x="5252622" y="5976799"/>
              <a:ext cx="608728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4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lg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 1 to 17,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M, 100-bp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, negative control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027641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CD38CB-1391-73BD-6182-4D7440CA82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>
            <a:extLst>
              <a:ext uri="{FF2B5EF4-FFF2-40B4-BE49-F238E27FC236}">
                <a16:creationId xmlns:a16="http://schemas.microsoft.com/office/drawing/2014/main" id="{0B16CEA5-64BB-E2BA-026B-FCFD81C8863E}"/>
              </a:ext>
            </a:extLst>
          </p:cNvPr>
          <p:cNvGrpSpPr/>
          <p:nvPr/>
        </p:nvGrpSpPr>
        <p:grpSpPr>
          <a:xfrm>
            <a:off x="3160556" y="1513076"/>
            <a:ext cx="6250412" cy="2990544"/>
            <a:chOff x="5234065" y="272302"/>
            <a:chExt cx="6250412" cy="2990544"/>
          </a:xfrm>
        </p:grpSpPr>
        <p:pic>
          <p:nvPicPr>
            <p:cNvPr id="25" name="Immagine 24" descr="Immagine che contiene schermata, violetto, Policromia, Magenta&#10;&#10;Il contenuto generato dall'IA potrebbe non essere corretto.">
              <a:extLst>
                <a:ext uri="{FF2B5EF4-FFF2-40B4-BE49-F238E27FC236}">
                  <a16:creationId xmlns:a16="http://schemas.microsoft.com/office/drawing/2014/main" id="{2EAD0445-C0DA-D7DD-9727-002C1613A5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43" t="-1" r="5811" b="47967"/>
            <a:stretch/>
          </p:blipFill>
          <p:spPr>
            <a:xfrm>
              <a:off x="5934610" y="272302"/>
              <a:ext cx="4469798" cy="2329384"/>
            </a:xfrm>
            <a:prstGeom prst="rect">
              <a:avLst/>
            </a:prstGeom>
          </p:spPr>
        </p:pic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457F9E73-F5FD-0D5C-32B0-2AE7DA13A78B}"/>
                </a:ext>
              </a:extLst>
            </p:cNvPr>
            <p:cNvSpPr txBox="1"/>
            <p:nvPr/>
          </p:nvSpPr>
          <p:spPr>
            <a:xfrm>
              <a:off x="7142199" y="648202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B3F0AE19-3214-4CA5-9D4C-DCDE9FE22AC5}"/>
                </a:ext>
              </a:extLst>
            </p:cNvPr>
            <p:cNvSpPr txBox="1"/>
            <p:nvPr/>
          </p:nvSpPr>
          <p:spPr>
            <a:xfrm>
              <a:off x="7381685" y="648202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8CB34D2D-AE0C-ED9C-1273-A296B8747E65}"/>
                </a:ext>
              </a:extLst>
            </p:cNvPr>
            <p:cNvSpPr txBox="1"/>
            <p:nvPr/>
          </p:nvSpPr>
          <p:spPr>
            <a:xfrm>
              <a:off x="7621171" y="648202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987BEFFD-57C1-9F6E-31B2-B574E3AEA0AE}"/>
                </a:ext>
              </a:extLst>
            </p:cNvPr>
            <p:cNvSpPr txBox="1"/>
            <p:nvPr/>
          </p:nvSpPr>
          <p:spPr>
            <a:xfrm>
              <a:off x="7920308" y="648201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D225118F-3301-47E7-1797-5DA6D02C0CB0}"/>
                </a:ext>
              </a:extLst>
            </p:cNvPr>
            <p:cNvSpPr txBox="1"/>
            <p:nvPr/>
          </p:nvSpPr>
          <p:spPr>
            <a:xfrm>
              <a:off x="8119785" y="648201"/>
              <a:ext cx="2394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9E483FC3-B24C-9865-23DE-E704A9163EC8}"/>
                </a:ext>
              </a:extLst>
            </p:cNvPr>
            <p:cNvSpPr txBox="1"/>
            <p:nvPr/>
          </p:nvSpPr>
          <p:spPr>
            <a:xfrm>
              <a:off x="9846355" y="702630"/>
              <a:ext cx="4188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-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19F4990B-88CF-90AC-3630-5F174B3CDBF0}"/>
                </a:ext>
              </a:extLst>
            </p:cNvPr>
            <p:cNvSpPr txBox="1"/>
            <p:nvPr/>
          </p:nvSpPr>
          <p:spPr>
            <a:xfrm>
              <a:off x="5234065" y="2801181"/>
              <a:ext cx="625041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5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lF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6, 7, 8, 9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M, 100-bp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, negative control.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22052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C5BB02F-A88D-11A4-7745-28BA21E664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uppo 23">
            <a:extLst>
              <a:ext uri="{FF2B5EF4-FFF2-40B4-BE49-F238E27FC236}">
                <a16:creationId xmlns:a16="http://schemas.microsoft.com/office/drawing/2014/main" id="{D609F452-BBF4-E1D6-8C60-615D8AE6F1E3}"/>
              </a:ext>
            </a:extLst>
          </p:cNvPr>
          <p:cNvGrpSpPr/>
          <p:nvPr/>
        </p:nvGrpSpPr>
        <p:grpSpPr>
          <a:xfrm>
            <a:off x="3791492" y="1235250"/>
            <a:ext cx="6116195" cy="4175341"/>
            <a:chOff x="-237801" y="205179"/>
            <a:chExt cx="6116195" cy="4175341"/>
          </a:xfrm>
        </p:grpSpPr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F848F74C-3574-A729-7246-F485184DF991}"/>
                </a:ext>
              </a:extLst>
            </p:cNvPr>
            <p:cNvSpPr txBox="1"/>
            <p:nvPr/>
          </p:nvSpPr>
          <p:spPr>
            <a:xfrm>
              <a:off x="-237801" y="3918855"/>
              <a:ext cx="611619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6. PCR for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ctio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</a:t>
              </a:r>
              <a:r>
                <a:rPr lang="en-US" sz="12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l</a:t>
              </a:r>
              <a:r>
                <a:rPr lang="en-US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gene. Data from one of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ree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re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hown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nes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rom 1 to 17 strains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sted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M, 50-bp DNA </a:t>
              </a:r>
              <a:r>
                <a:rPr lang="it-IT" sz="12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adder</a:t>
              </a:r>
              <a:r>
                <a: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; lane N- negative control. </a:t>
              </a:r>
            </a:p>
          </p:txBody>
        </p:sp>
        <p:pic>
          <p:nvPicPr>
            <p:cNvPr id="30" name="Immagine 29" descr="Immagine che contiene schermata, viola, Policromia, violetto&#10;&#10;Il contenuto generato dall'IA potrebbe non essere corretto.">
              <a:extLst>
                <a:ext uri="{FF2B5EF4-FFF2-40B4-BE49-F238E27FC236}">
                  <a16:creationId xmlns:a16="http://schemas.microsoft.com/office/drawing/2014/main" id="{4377BB7E-9E81-233A-34C4-FBB5CD7D48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80" t="17942" r="10701" b="15254"/>
            <a:stretch/>
          </p:blipFill>
          <p:spPr>
            <a:xfrm>
              <a:off x="200869" y="205179"/>
              <a:ext cx="4727970" cy="3493311"/>
            </a:xfrm>
            <a:prstGeom prst="rect">
              <a:avLst/>
            </a:prstGeom>
          </p:spPr>
        </p:pic>
        <p:grpSp>
          <p:nvGrpSpPr>
            <p:cNvPr id="22" name="Gruppo 21">
              <a:extLst>
                <a:ext uri="{FF2B5EF4-FFF2-40B4-BE49-F238E27FC236}">
                  <a16:creationId xmlns:a16="http://schemas.microsoft.com/office/drawing/2014/main" id="{F8A2EB9A-AA92-156F-5418-DF3D7CC8CAF4}"/>
                </a:ext>
              </a:extLst>
            </p:cNvPr>
            <p:cNvGrpSpPr/>
            <p:nvPr/>
          </p:nvGrpSpPr>
          <p:grpSpPr>
            <a:xfrm>
              <a:off x="393056" y="272302"/>
              <a:ext cx="4563968" cy="275479"/>
              <a:chOff x="393056" y="272302"/>
              <a:chExt cx="4563968" cy="275479"/>
            </a:xfrm>
          </p:grpSpPr>
          <p:sp>
            <p:nvSpPr>
              <p:cNvPr id="3" name="CasellaDiTesto 2">
                <a:extLst>
                  <a:ext uri="{FF2B5EF4-FFF2-40B4-BE49-F238E27FC236}">
                    <a16:creationId xmlns:a16="http://schemas.microsoft.com/office/drawing/2014/main" id="{E2C606CE-3A95-B858-727A-5F8C7B1ECDB3}"/>
                  </a:ext>
                </a:extLst>
              </p:cNvPr>
              <p:cNvSpPr txBox="1"/>
              <p:nvPr/>
            </p:nvSpPr>
            <p:spPr>
              <a:xfrm>
                <a:off x="393056" y="29986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sp>
            <p:nvSpPr>
              <p:cNvPr id="4" name="CasellaDiTesto 3">
                <a:extLst>
                  <a:ext uri="{FF2B5EF4-FFF2-40B4-BE49-F238E27FC236}">
                    <a16:creationId xmlns:a16="http://schemas.microsoft.com/office/drawing/2014/main" id="{2E96B194-6D37-13BD-AA09-FE9D70A5F746}"/>
                  </a:ext>
                </a:extLst>
              </p:cNvPr>
              <p:cNvSpPr txBox="1"/>
              <p:nvPr/>
            </p:nvSpPr>
            <p:spPr>
              <a:xfrm>
                <a:off x="632542" y="29986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2322A279-8B27-6BB5-A5CD-307C8735D1B5}"/>
                  </a:ext>
                </a:extLst>
              </p:cNvPr>
              <p:cNvSpPr txBox="1"/>
              <p:nvPr/>
            </p:nvSpPr>
            <p:spPr>
              <a:xfrm>
                <a:off x="872028" y="299859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4917C42A-E9EE-D923-4869-AD086683A964}"/>
                  </a:ext>
                </a:extLst>
              </p:cNvPr>
              <p:cNvSpPr txBox="1"/>
              <p:nvPr/>
            </p:nvSpPr>
            <p:spPr>
              <a:xfrm>
                <a:off x="1089742" y="292376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CD2A04B0-FD8E-E2B6-0950-42F755896C88}"/>
                  </a:ext>
                </a:extLst>
              </p:cNvPr>
              <p:cNvSpPr txBox="1"/>
              <p:nvPr/>
            </p:nvSpPr>
            <p:spPr>
              <a:xfrm>
                <a:off x="1303701" y="301560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sp>
            <p:nvSpPr>
              <p:cNvPr id="8" name="CasellaDiTesto 7">
                <a:extLst>
                  <a:ext uri="{FF2B5EF4-FFF2-40B4-BE49-F238E27FC236}">
                    <a16:creationId xmlns:a16="http://schemas.microsoft.com/office/drawing/2014/main" id="{30E59DD2-FD73-FF9F-5AF3-5DA406CB8134}"/>
                  </a:ext>
                </a:extLst>
              </p:cNvPr>
              <p:cNvSpPr txBox="1"/>
              <p:nvPr/>
            </p:nvSpPr>
            <p:spPr>
              <a:xfrm>
                <a:off x="1495888" y="292375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</a:p>
            </p:txBody>
          </p:sp>
          <p:sp>
            <p:nvSpPr>
              <p:cNvPr id="9" name="CasellaDiTesto 8">
                <a:extLst>
                  <a:ext uri="{FF2B5EF4-FFF2-40B4-BE49-F238E27FC236}">
                    <a16:creationId xmlns:a16="http://schemas.microsoft.com/office/drawing/2014/main" id="{13F53F1E-FBF5-E232-F2F2-CFC186368478}"/>
                  </a:ext>
                </a:extLst>
              </p:cNvPr>
              <p:cNvSpPr txBox="1"/>
              <p:nvPr/>
            </p:nvSpPr>
            <p:spPr>
              <a:xfrm>
                <a:off x="1782673" y="281488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</a:p>
            </p:txBody>
          </p:sp>
          <p:sp>
            <p:nvSpPr>
              <p:cNvPr id="10" name="CasellaDiTesto 9">
                <a:extLst>
                  <a:ext uri="{FF2B5EF4-FFF2-40B4-BE49-F238E27FC236}">
                    <a16:creationId xmlns:a16="http://schemas.microsoft.com/office/drawing/2014/main" id="{F98AA174-7D21-D893-2B7C-9EC2365EA3E8}"/>
                  </a:ext>
                </a:extLst>
              </p:cNvPr>
              <p:cNvSpPr txBox="1"/>
              <p:nvPr/>
            </p:nvSpPr>
            <p:spPr>
              <a:xfrm>
                <a:off x="1949715" y="281487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</a:p>
            </p:txBody>
          </p:sp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46DD3D53-A8DE-722A-50EB-A528077405DD}"/>
                  </a:ext>
                </a:extLst>
              </p:cNvPr>
              <p:cNvSpPr txBox="1"/>
              <p:nvPr/>
            </p:nvSpPr>
            <p:spPr>
              <a:xfrm>
                <a:off x="2403542" y="272304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</a:p>
            </p:txBody>
          </p:sp>
          <p:sp>
            <p:nvSpPr>
              <p:cNvPr id="12" name="CasellaDiTesto 11">
                <a:extLst>
                  <a:ext uri="{FF2B5EF4-FFF2-40B4-BE49-F238E27FC236}">
                    <a16:creationId xmlns:a16="http://schemas.microsoft.com/office/drawing/2014/main" id="{E0E1FA27-1376-3C0B-23E5-0CA91EC7F06F}"/>
                  </a:ext>
                </a:extLst>
              </p:cNvPr>
              <p:cNvSpPr txBox="1"/>
              <p:nvPr/>
            </p:nvSpPr>
            <p:spPr>
              <a:xfrm>
                <a:off x="2189201" y="290673"/>
                <a:ext cx="23948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</a:p>
            </p:txBody>
          </p:sp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3639A2A9-09A9-DC73-E021-43E7168E1FF3}"/>
                  </a:ext>
                </a:extLst>
              </p:cNvPr>
              <p:cNvSpPr txBox="1"/>
              <p:nvPr/>
            </p:nvSpPr>
            <p:spPr>
              <a:xfrm>
                <a:off x="2606135" y="272304"/>
                <a:ext cx="3191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EAA24F1E-4943-7952-EAD1-15CF2C9B6346}"/>
                  </a:ext>
                </a:extLst>
              </p:cNvPr>
              <p:cNvSpPr txBox="1"/>
              <p:nvPr/>
            </p:nvSpPr>
            <p:spPr>
              <a:xfrm>
                <a:off x="2820297" y="281487"/>
                <a:ext cx="356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5B9C62E4-6515-D4E7-1D8E-C97F416C9EE5}"/>
                  </a:ext>
                </a:extLst>
              </p:cNvPr>
              <p:cNvSpPr txBox="1"/>
              <p:nvPr/>
            </p:nvSpPr>
            <p:spPr>
              <a:xfrm>
                <a:off x="3057894" y="281487"/>
                <a:ext cx="3676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9AB65598-8CBB-344B-0D05-3AC01E439B85}"/>
                  </a:ext>
                </a:extLst>
              </p:cNvPr>
              <p:cNvSpPr txBox="1"/>
              <p:nvPr/>
            </p:nvSpPr>
            <p:spPr>
              <a:xfrm>
                <a:off x="3289068" y="281487"/>
                <a:ext cx="3310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</a:p>
            </p:txBody>
          </p:sp>
          <p:sp>
            <p:nvSpPr>
              <p:cNvPr id="17" name="CasellaDiTesto 16">
                <a:extLst>
                  <a:ext uri="{FF2B5EF4-FFF2-40B4-BE49-F238E27FC236}">
                    <a16:creationId xmlns:a16="http://schemas.microsoft.com/office/drawing/2014/main" id="{158CC491-0FC1-4CA5-A75C-A92F26CE7D00}"/>
                  </a:ext>
                </a:extLst>
              </p:cNvPr>
              <p:cNvSpPr txBox="1"/>
              <p:nvPr/>
            </p:nvSpPr>
            <p:spPr>
              <a:xfrm>
                <a:off x="3482810" y="290673"/>
                <a:ext cx="3310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</a:p>
            </p:txBody>
          </p:sp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194A491A-6D91-3467-A5DC-5345F1A77F13}"/>
                  </a:ext>
                </a:extLst>
              </p:cNvPr>
              <p:cNvSpPr txBox="1"/>
              <p:nvPr/>
            </p:nvSpPr>
            <p:spPr>
              <a:xfrm>
                <a:off x="3730910" y="290673"/>
                <a:ext cx="31938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</a:t>
                </a:r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2142564F-7B58-0994-E9C1-1F753A47744E}"/>
                  </a:ext>
                </a:extLst>
              </p:cNvPr>
              <p:cNvSpPr txBox="1"/>
              <p:nvPr/>
            </p:nvSpPr>
            <p:spPr>
              <a:xfrm>
                <a:off x="3931326" y="290673"/>
                <a:ext cx="31566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E3651FB9-BB6B-B05B-C5C2-A99479F73BC0}"/>
                  </a:ext>
                </a:extLst>
              </p:cNvPr>
              <p:cNvSpPr txBox="1"/>
              <p:nvPr/>
            </p:nvSpPr>
            <p:spPr>
              <a:xfrm>
                <a:off x="4167718" y="281487"/>
                <a:ext cx="35623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1E01DF5D-951D-45C1-72B4-64887D07E219}"/>
                  </a:ext>
                </a:extLst>
              </p:cNvPr>
              <p:cNvSpPr txBox="1"/>
              <p:nvPr/>
            </p:nvSpPr>
            <p:spPr>
              <a:xfrm>
                <a:off x="4625932" y="272302"/>
                <a:ext cx="33109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449466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363</Words>
  <Application>Microsoft Office PowerPoint</Application>
  <PresentationFormat>Widescreen</PresentationFormat>
  <Paragraphs>79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ESCA PAOLA NOCERA</dc:creator>
  <cp:lastModifiedBy>FRANCESCA PAOLA NOCERA</cp:lastModifiedBy>
  <cp:revision>1</cp:revision>
  <dcterms:created xsi:type="dcterms:W3CDTF">2025-04-11T20:15:13Z</dcterms:created>
  <dcterms:modified xsi:type="dcterms:W3CDTF">2025-04-29T09:20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2ad0b24d-6422-44b0-b3de-abb3a9e8c81a_Enabled">
    <vt:lpwstr>true</vt:lpwstr>
  </property>
  <property fmtid="{D5CDD505-2E9C-101B-9397-08002B2CF9AE}" pid="3" name="MSIP_Label_2ad0b24d-6422-44b0-b3de-abb3a9e8c81a_SetDate">
    <vt:lpwstr>2025-04-11T21:13:44Z</vt:lpwstr>
  </property>
  <property fmtid="{D5CDD505-2E9C-101B-9397-08002B2CF9AE}" pid="4" name="MSIP_Label_2ad0b24d-6422-44b0-b3de-abb3a9e8c81a_Method">
    <vt:lpwstr>Standard</vt:lpwstr>
  </property>
  <property fmtid="{D5CDD505-2E9C-101B-9397-08002B2CF9AE}" pid="5" name="MSIP_Label_2ad0b24d-6422-44b0-b3de-abb3a9e8c81a_Name">
    <vt:lpwstr>defa4170-0d19-0005-0004-bc88714345d2</vt:lpwstr>
  </property>
  <property fmtid="{D5CDD505-2E9C-101B-9397-08002B2CF9AE}" pid="6" name="MSIP_Label_2ad0b24d-6422-44b0-b3de-abb3a9e8c81a_SiteId">
    <vt:lpwstr>2fcfe26a-bb62-46b0-b1e3-28f9da0c45fd</vt:lpwstr>
  </property>
  <property fmtid="{D5CDD505-2E9C-101B-9397-08002B2CF9AE}" pid="7" name="MSIP_Label_2ad0b24d-6422-44b0-b3de-abb3a9e8c81a_ActionId">
    <vt:lpwstr>f1857154-66bf-4c0e-b12b-f76a11021533</vt:lpwstr>
  </property>
  <property fmtid="{D5CDD505-2E9C-101B-9397-08002B2CF9AE}" pid="8" name="MSIP_Label_2ad0b24d-6422-44b0-b3de-abb3a9e8c81a_ContentBits">
    <vt:lpwstr>0</vt:lpwstr>
  </property>
  <property fmtid="{D5CDD505-2E9C-101B-9397-08002B2CF9AE}" pid="9" name="MSIP_Label_2ad0b24d-6422-44b0-b3de-abb3a9e8c81a_Tag">
    <vt:lpwstr>10, 3, 0, 1</vt:lpwstr>
  </property>
</Properties>
</file>